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sldIdLst>
    <p:sldId id="256" r:id="rId2"/>
    <p:sldId id="257" r:id="rId3"/>
    <p:sldId id="263" r:id="rId4"/>
    <p:sldId id="260" r:id="rId5"/>
    <p:sldId id="261" r:id="rId6"/>
    <p:sldId id="262" r:id="rId7"/>
    <p:sldId id="259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000" autoAdjust="0"/>
    <p:restoredTop sz="94660"/>
  </p:normalViewPr>
  <p:slideViewPr>
    <p:cSldViewPr snapToGrid="0">
      <p:cViewPr varScale="1">
        <p:scale>
          <a:sx n="65" d="100"/>
          <a:sy n="65" d="100"/>
        </p:scale>
        <p:origin x="936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4C52350-77C6-42ED-B8A4-CAEAA5F611D0}" type="datetimeFigureOut">
              <a:rPr lang="en-US" smtClean="0"/>
              <a:t>09-Sep-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C390E46-EACF-4F49-B8F8-60F3D96441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556069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C390E46-EACF-4F49-B8F8-60F3D9644130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657994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30EEB7-FC81-2D91-5C31-B7CDD104E32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B140AE3-526D-52DA-C02A-228F9666266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EF3F77E-FE55-0AA3-69F2-D2282E3D03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9D66CA-531B-4BAF-835C-F7C71DE0C88C}" type="datetimeFigureOut">
              <a:rPr lang="en-US" smtClean="0"/>
              <a:t>09-Sep-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58E14C0-46FE-B0EF-60FB-467C4BE527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F6721E0-444E-8884-9C6C-89109795C5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40DD15-01A8-4C66-9B9F-8F3C4506C0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03942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674ACA-3CA1-1DF2-5BBA-C838B047A1E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28FE04A-94EB-173A-A706-B82EECB7E6B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36E042E-2E5E-EA13-81B3-42383D9E2C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9D66CA-531B-4BAF-835C-F7C71DE0C88C}" type="datetimeFigureOut">
              <a:rPr lang="en-US" smtClean="0"/>
              <a:t>09-Sep-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B722BCD-77BE-A0F8-F397-0FF0B50646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DF6C95A-9B5C-9A0B-B3A4-F965C09E53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40DD15-01A8-4C66-9B9F-8F3C4506C0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55559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3A5434C-B732-FF13-63DA-C6A2498E545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9336984-CEEA-0EAB-7454-A03724A3FFA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72D7121-3716-0068-AA20-952B7BDD9C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9D66CA-531B-4BAF-835C-F7C71DE0C88C}" type="datetimeFigureOut">
              <a:rPr lang="en-US" smtClean="0"/>
              <a:t>09-Sep-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2DF9ACD-9290-60C3-F475-6794FC7CD1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26E70C4-605E-FB7E-5988-E97FC98553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40DD15-01A8-4C66-9B9F-8F3C4506C0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90204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4266CA-95E4-7C52-30A8-46406C83E49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DE5852C-81D6-9D41-A0F0-EB597C0E475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2FD65D9-3ACB-36BC-1CDA-6A2154209F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9D66CA-531B-4BAF-835C-F7C71DE0C88C}" type="datetimeFigureOut">
              <a:rPr lang="en-US" smtClean="0"/>
              <a:t>09-Sep-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521F950-2175-8876-4F16-7A25839880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67E4A08-4C92-5932-2F8D-093C6C8434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40DD15-01A8-4C66-9B9F-8F3C4506C0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8664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4D8D83D-EC05-BBA3-8CD8-65483D17B66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F62B85A-8A10-52F3-B2A1-491B84E0AD2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BA3BD41-56B2-6415-40AF-9E0D177010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9D66CA-531B-4BAF-835C-F7C71DE0C88C}" type="datetimeFigureOut">
              <a:rPr lang="en-US" smtClean="0"/>
              <a:t>09-Sep-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56F181F-DAEA-835B-7D12-EC8A9604E1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FD94C28-9740-ADFB-A2D8-B511CD4E17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40DD15-01A8-4C66-9B9F-8F3C4506C0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02046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54A9F1-1E44-5BF1-7716-B8F90F49E00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F559E60-261B-5E50-CC7A-EC3D21BA767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FBE905E-B82A-BAAD-51ED-20F9CDBC89F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3D1CD63-121F-A9DB-B527-854B69FB6F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9D66CA-531B-4BAF-835C-F7C71DE0C88C}" type="datetimeFigureOut">
              <a:rPr lang="en-US" smtClean="0"/>
              <a:t>09-Sep-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96919E4-90D8-9078-F5C2-C9AE646F2E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8D41139-2B49-A092-AA85-976BA7BE9C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40DD15-01A8-4C66-9B9F-8F3C4506C0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05070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D0FB61-3056-9364-4075-EC7E398F64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27DC07D-AD43-625F-3233-EB779A5E9AF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4A4A57B-17A4-80C7-96B5-B97A54AACA3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F7BA8BE-12CE-C49E-A6FD-E6A08606408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7E5F764-4375-FA52-0894-BAF3410D07C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F3B4290-4FE2-F830-FA17-FE30829B43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9D66CA-531B-4BAF-835C-F7C71DE0C88C}" type="datetimeFigureOut">
              <a:rPr lang="en-US" smtClean="0"/>
              <a:t>09-Sep-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06F5CAD-9B71-B244-3D36-6D8083D357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C9B52C1-6569-1DBF-5112-B9EB2FB613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40DD15-01A8-4C66-9B9F-8F3C4506C0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40573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367FFD-36DE-9760-2916-7602776D762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10D027F-E6DA-CFC4-476B-1BD4907868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9D66CA-531B-4BAF-835C-F7C71DE0C88C}" type="datetimeFigureOut">
              <a:rPr lang="en-US" smtClean="0"/>
              <a:t>09-Sep-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3B88738-FFF9-7954-CA0E-C2EFC3887F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1573ECE-2942-4AD9-EBC5-A99DB29F6B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40DD15-01A8-4C66-9B9F-8F3C4506C0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88314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4325A53-CFE9-3AEB-C429-775611C5C7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9D66CA-531B-4BAF-835C-F7C71DE0C88C}" type="datetimeFigureOut">
              <a:rPr lang="en-US" smtClean="0"/>
              <a:t>09-Sep-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6BE347F-18DC-E14C-201B-B994A6196D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165DE07-4C1C-9232-0B9B-1B0FA99E88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40DD15-01A8-4C66-9B9F-8F3C4506C0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65339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9934C75-B174-FC13-52D1-6537EF08760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1FE673A-63C1-4D9C-34C8-F9F09C5BCB2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388EC85-32B1-F74F-5BA0-DDB604AF452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4B6866B-04F5-AB7E-C76D-31026B0403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9D66CA-531B-4BAF-835C-F7C71DE0C88C}" type="datetimeFigureOut">
              <a:rPr lang="en-US" smtClean="0"/>
              <a:t>09-Sep-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310C684-8092-17B0-03DD-C7BC5F875B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A9C7C20-668E-1D65-5C16-264E4ACF49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40DD15-01A8-4C66-9B9F-8F3C4506C0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72764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4539AFD-93B9-7BE6-032A-E03BB742D7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A5447A4-80B8-A8F4-F7AE-D5AD4E15CA9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00761AE-C802-4BA6-42E5-9565845B0C3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9086E14-E918-09CD-3CA2-5DE890F382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9D66CA-531B-4BAF-835C-F7C71DE0C88C}" type="datetimeFigureOut">
              <a:rPr lang="en-US" smtClean="0"/>
              <a:t>09-Sep-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087F592-C520-7AF2-0A66-E523471355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310E9EA-6F0E-8356-52A2-2D4E15F13D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40DD15-01A8-4C66-9B9F-8F3C4506C0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82443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4F24560-A259-6968-A78D-1D09B4D0D4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0D97523-31FC-B83E-74E0-BD030CB4A37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1CD16C9-7895-D767-DA1E-5DCF49523B6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79D66CA-531B-4BAF-835C-F7C71DE0C88C}" type="datetimeFigureOut">
              <a:rPr lang="en-US" smtClean="0"/>
              <a:t>09-Sep-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EDBF17A-464A-96DC-E51B-4487FCBB2F7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6D7A04A-01A5-AABF-5AFC-61A620A85CD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D40DD15-01A8-4C66-9B9F-8F3C4506C0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50143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"/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.jpe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"/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.jpe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"/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.jpe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tif"/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.jpe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g"/><Relationship Id="rId2" Type="http://schemas.openxmlformats.org/officeDocument/2006/relationships/image" Target="../media/image8.jp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D9311A-C6D4-82F3-677D-860289EE96C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745226" y="1653304"/>
            <a:ext cx="9144000" cy="2387600"/>
          </a:xfrm>
        </p:spPr>
        <p:txBody>
          <a:bodyPr>
            <a:noAutofit/>
          </a:bodyPr>
          <a:lstStyle/>
          <a:p>
            <a:pPr algn="just"/>
            <a:r>
              <a:rPr lang="en-US" sz="3600" b="1" dirty="0"/>
              <a:t>Nature’s Synergy: Cellular and Molecular Evaluation of Snail Slime and Its Principal Component, Glycolic Acid, on Keratinocytes, with Preliminary Evidence from Endothelial Cells</a:t>
            </a:r>
            <a:endParaRPr lang="en-US" sz="3600" dirty="0"/>
          </a:p>
        </p:txBody>
      </p:sp>
      <p:sp>
        <p:nvSpPr>
          <p:cNvPr id="39" name="Subtitle 2">
            <a:extLst>
              <a:ext uri="{FF2B5EF4-FFF2-40B4-BE49-F238E27FC236}">
                <a16:creationId xmlns:a16="http://schemas.microsoft.com/office/drawing/2014/main" id="{4ECED874-56D4-967B-A6C3-6A88A8D2BA19}"/>
              </a:ext>
            </a:extLst>
          </p:cNvPr>
          <p:cNvSpPr txBox="1">
            <a:spLocks/>
          </p:cNvSpPr>
          <p:nvPr/>
        </p:nvSpPr>
        <p:spPr>
          <a:xfrm>
            <a:off x="459948" y="246688"/>
            <a:ext cx="3588774" cy="380027"/>
          </a:xfrm>
          <a:prstGeom prst="rect">
            <a:avLst/>
          </a:prstGeom>
        </p:spPr>
        <p:txBody>
          <a:bodyPr>
            <a:normAutofit fontScale="85000" lnSpcReduction="20000"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US" b="1" dirty="0"/>
              <a:t>Supplementary material</a:t>
            </a:r>
          </a:p>
        </p:txBody>
      </p:sp>
    </p:spTree>
    <p:extLst>
      <p:ext uri="{BB962C8B-B14F-4D97-AF65-F5344CB8AC3E}">
        <p14:creationId xmlns:p14="http://schemas.microsoft.com/office/powerpoint/2010/main" val="145218684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>
            <a:extLst>
              <a:ext uri="{FF2B5EF4-FFF2-40B4-BE49-F238E27FC236}">
                <a16:creationId xmlns:a16="http://schemas.microsoft.com/office/drawing/2014/main" id="{2FD2883A-68C5-10C5-D320-31C8C1F8BDD7}"/>
              </a:ext>
            </a:extLst>
          </p:cNvPr>
          <p:cNvGrpSpPr/>
          <p:nvPr/>
        </p:nvGrpSpPr>
        <p:grpSpPr>
          <a:xfrm>
            <a:off x="742413" y="317598"/>
            <a:ext cx="10436864" cy="6222804"/>
            <a:chOff x="742413" y="317598"/>
            <a:chExt cx="10436864" cy="6222804"/>
          </a:xfrm>
        </p:grpSpPr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47FC58CF-C9F9-6418-EF5E-9CCEE26A375E}"/>
                </a:ext>
              </a:extLst>
            </p:cNvPr>
            <p:cNvGrpSpPr/>
            <p:nvPr/>
          </p:nvGrpSpPr>
          <p:grpSpPr>
            <a:xfrm>
              <a:off x="2093210" y="317598"/>
              <a:ext cx="7759634" cy="5280545"/>
              <a:chOff x="1591765" y="937030"/>
              <a:chExt cx="7759634" cy="5280545"/>
            </a:xfrm>
          </p:grpSpPr>
          <p:pic>
            <p:nvPicPr>
              <p:cNvPr id="1026" name="Picture 2" descr="_image_0">
                <a:extLst>
                  <a:ext uri="{FF2B5EF4-FFF2-40B4-BE49-F238E27FC236}">
                    <a16:creationId xmlns:a16="http://schemas.microsoft.com/office/drawing/2014/main" id="{BC72D275-E130-2E4E-488D-F363A8F83A69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1262" r="43085"/>
              <a:stretch>
                <a:fillRect/>
              </a:stretch>
            </p:blipFill>
            <p:spPr bwMode="auto">
              <a:xfrm>
                <a:off x="1591765" y="2309272"/>
                <a:ext cx="902039" cy="3878807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grpSp>
            <p:nvGrpSpPr>
              <p:cNvPr id="43" name="Group 42">
                <a:extLst>
                  <a:ext uri="{FF2B5EF4-FFF2-40B4-BE49-F238E27FC236}">
                    <a16:creationId xmlns:a16="http://schemas.microsoft.com/office/drawing/2014/main" id="{8B0454A8-6662-AD89-1F77-DDB31D04EF81}"/>
                  </a:ext>
                </a:extLst>
              </p:cNvPr>
              <p:cNvGrpSpPr/>
              <p:nvPr/>
            </p:nvGrpSpPr>
            <p:grpSpPr>
              <a:xfrm>
                <a:off x="2840601" y="3290500"/>
                <a:ext cx="863575" cy="276999"/>
                <a:chOff x="1727608" y="3776717"/>
                <a:chExt cx="863575" cy="276999"/>
              </a:xfrm>
            </p:grpSpPr>
            <p:sp>
              <p:nvSpPr>
                <p:cNvPr id="40" name="TextBox 39">
                  <a:extLst>
                    <a:ext uri="{FF2B5EF4-FFF2-40B4-BE49-F238E27FC236}">
                      <a16:creationId xmlns:a16="http://schemas.microsoft.com/office/drawing/2014/main" id="{31B054EA-5FF0-6370-AF99-5F65738B607D}"/>
                    </a:ext>
                  </a:extLst>
                </p:cNvPr>
                <p:cNvSpPr txBox="1"/>
                <p:nvPr/>
              </p:nvSpPr>
              <p:spPr>
                <a:xfrm>
                  <a:off x="1727608" y="3776717"/>
                  <a:ext cx="64953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80 </a:t>
                  </a:r>
                  <a:r>
                    <a:rPr lang="en-US" sz="1200" b="1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kDa</a:t>
                  </a:r>
                  <a:endPara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42" name="Straight Arrow Connector 41">
                  <a:extLst>
                    <a:ext uri="{FF2B5EF4-FFF2-40B4-BE49-F238E27FC236}">
                      <a16:creationId xmlns:a16="http://schemas.microsoft.com/office/drawing/2014/main" id="{069DAAE3-1481-5689-1795-9E26B740AB5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2377145" y="3944712"/>
                  <a:ext cx="214038" cy="1"/>
                </a:xfrm>
                <a:prstGeom prst="straightConnector1">
                  <a:avLst/>
                </a:prstGeom>
                <a:ln w="28575">
                  <a:tailEnd type="triangle"/>
                </a:ln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</p:grpSp>
          <p:pic>
            <p:nvPicPr>
              <p:cNvPr id="3" name="Picture 2" descr="A close-up of a test strip&#10;&#10;AI-generated content may be incorrect.">
                <a:extLst>
                  <a:ext uri="{FF2B5EF4-FFF2-40B4-BE49-F238E27FC236}">
                    <a16:creationId xmlns:a16="http://schemas.microsoft.com/office/drawing/2014/main" id="{E63E781F-050A-1516-060B-37965E79FB8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731699" y="1306362"/>
                <a:ext cx="5619700" cy="4911213"/>
              </a:xfrm>
              <a:prstGeom prst="rect">
                <a:avLst/>
              </a:prstGeom>
            </p:spPr>
          </p:pic>
          <p:cxnSp>
            <p:nvCxnSpPr>
              <p:cNvPr id="4" name="Straight Arrow Connector 3">
                <a:extLst>
                  <a:ext uri="{FF2B5EF4-FFF2-40B4-BE49-F238E27FC236}">
                    <a16:creationId xmlns:a16="http://schemas.microsoft.com/office/drawing/2014/main" id="{7802E1C0-43AE-AFBC-AE32-31EC30726B67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2375820" y="3442900"/>
                <a:ext cx="517874" cy="0"/>
              </a:xfrm>
              <a:prstGeom prst="straightConnector1">
                <a:avLst/>
              </a:prstGeom>
              <a:ln w="28575">
                <a:tailEnd type="triangle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8F310DC4-AA9E-0E95-7C1C-254602059E4E}"/>
                  </a:ext>
                </a:extLst>
              </p:cNvPr>
              <p:cNvSpPr txBox="1"/>
              <p:nvPr/>
            </p:nvSpPr>
            <p:spPr>
              <a:xfrm>
                <a:off x="4437136" y="937030"/>
                <a:ext cx="4208825" cy="3693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b="1" dirty="0"/>
                  <a:t>Membrane cut into two parts at 80 </a:t>
                </a:r>
                <a:r>
                  <a:rPr lang="en-US" b="1" dirty="0" err="1"/>
                  <a:t>kDa</a:t>
                </a:r>
                <a:endParaRPr lang="en-US" dirty="0"/>
              </a:p>
            </p:txBody>
          </p:sp>
        </p:grpSp>
        <p:sp>
          <p:nvSpPr>
            <p:cNvPr id="5" name="Subtitle 2">
              <a:extLst>
                <a:ext uri="{FF2B5EF4-FFF2-40B4-BE49-F238E27FC236}">
                  <a16:creationId xmlns:a16="http://schemas.microsoft.com/office/drawing/2014/main" id="{0B86630C-C28E-987F-E463-A340A38ABFD9}"/>
                </a:ext>
              </a:extLst>
            </p:cNvPr>
            <p:cNvSpPr txBox="1">
              <a:spLocks/>
            </p:cNvSpPr>
            <p:nvPr/>
          </p:nvSpPr>
          <p:spPr>
            <a:xfrm>
              <a:off x="742413" y="5934102"/>
              <a:ext cx="10436864" cy="606300"/>
            </a:xfrm>
            <a:prstGeom prst="rect">
              <a:avLst/>
            </a:prstGeom>
          </p:spPr>
          <p:txBody>
            <a:bodyPr>
              <a:normAutofit/>
            </a:bodyPr>
            <a:lstStyle>
              <a:lvl1pPr marL="228600" indent="-228600" algn="l" defTabSz="914400" rtl="0" eaLnBrk="1" latinLnBrk="0" hangingPunct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6858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430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6002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0574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5146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9718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4290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8862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indent="0">
                <a:buNone/>
              </a:pPr>
              <a:r>
                <a:rPr lang="en-US" sz="2400" b="1" dirty="0"/>
                <a:t>Figure S1: </a:t>
              </a:r>
              <a:r>
                <a:rPr lang="en-US" sz="2400" dirty="0"/>
                <a:t>Original nitrocellulose membrane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78457018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62AD0DF-7113-4974-7CC8-AD3F7CA63A1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694464D3-7412-9A61-9576-E99B4541DF52}"/>
              </a:ext>
            </a:extLst>
          </p:cNvPr>
          <p:cNvGrpSpPr/>
          <p:nvPr/>
        </p:nvGrpSpPr>
        <p:grpSpPr>
          <a:xfrm>
            <a:off x="289844" y="990313"/>
            <a:ext cx="11393951" cy="5377571"/>
            <a:chOff x="289844" y="990313"/>
            <a:chExt cx="11393951" cy="5377571"/>
          </a:xfrm>
        </p:grpSpPr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E31E7CBF-8597-08FC-BD87-13775AC5FE02}"/>
                </a:ext>
              </a:extLst>
            </p:cNvPr>
            <p:cNvSpPr txBox="1"/>
            <p:nvPr/>
          </p:nvSpPr>
          <p:spPr>
            <a:xfrm>
              <a:off x="3341586" y="990313"/>
              <a:ext cx="6908543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800" b="1" dirty="0"/>
                <a:t>Tubulin						PI3K</a:t>
              </a:r>
              <a:endParaRPr lang="en-US" dirty="0"/>
            </a:p>
          </p:txBody>
        </p:sp>
        <p:pic>
          <p:nvPicPr>
            <p:cNvPr id="8" name="Picture 7" descr="A close-up of a line&#10;&#10;AI-generated content may be incorrect.">
              <a:extLst>
                <a:ext uri="{FF2B5EF4-FFF2-40B4-BE49-F238E27FC236}">
                  <a16:creationId xmlns:a16="http://schemas.microsoft.com/office/drawing/2014/main" id="{A5EF3760-9223-4B1D-63D1-93227A25D648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717909" y="1547665"/>
              <a:ext cx="4686300" cy="3670300"/>
            </a:xfrm>
            <a:prstGeom prst="rect">
              <a:avLst/>
            </a:prstGeom>
          </p:spPr>
        </p:pic>
        <p:pic>
          <p:nvPicPr>
            <p:cNvPr id="10" name="Picture 9" descr="A close-up of a test&#10;&#10;AI-generated content may be incorrect.">
              <a:extLst>
                <a:ext uri="{FF2B5EF4-FFF2-40B4-BE49-F238E27FC236}">
                  <a16:creationId xmlns:a16="http://schemas.microsoft.com/office/drawing/2014/main" id="{9F4D1BF8-3979-3980-85F8-E6ABAF993D5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997495" y="1547665"/>
              <a:ext cx="4686300" cy="3708400"/>
            </a:xfrm>
            <a:prstGeom prst="rect">
              <a:avLst/>
            </a:prstGeom>
          </p:spPr>
        </p:pic>
        <p:grpSp>
          <p:nvGrpSpPr>
            <p:cNvPr id="38" name="Group 37">
              <a:extLst>
                <a:ext uri="{FF2B5EF4-FFF2-40B4-BE49-F238E27FC236}">
                  <a16:creationId xmlns:a16="http://schemas.microsoft.com/office/drawing/2014/main" id="{97E5386E-2A14-A47E-34BE-8178379423A4}"/>
                </a:ext>
              </a:extLst>
            </p:cNvPr>
            <p:cNvGrpSpPr/>
            <p:nvPr/>
          </p:nvGrpSpPr>
          <p:grpSpPr>
            <a:xfrm>
              <a:off x="2722456" y="3003357"/>
              <a:ext cx="2613182" cy="965307"/>
              <a:chOff x="2722456" y="3003357"/>
              <a:chExt cx="2613182" cy="965307"/>
            </a:xfrm>
          </p:grpSpPr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ABF8B519-ED2B-FC80-D76C-A75CD5C1EBD8}"/>
                  </a:ext>
                </a:extLst>
              </p:cNvPr>
              <p:cNvSpPr txBox="1"/>
              <p:nvPr/>
            </p:nvSpPr>
            <p:spPr>
              <a:xfrm>
                <a:off x="2931773" y="3003357"/>
                <a:ext cx="508473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4 h</a:t>
                </a: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9A5FFFAB-B4C8-885B-4B16-302FB3F4562A}"/>
                  </a:ext>
                </a:extLst>
              </p:cNvPr>
              <p:cNvSpPr txBox="1"/>
              <p:nvPr/>
            </p:nvSpPr>
            <p:spPr>
              <a:xfrm rot="17813602">
                <a:off x="2537627" y="3506835"/>
                <a:ext cx="646658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TRL</a:t>
                </a:r>
                <a:endParaRPr lang="en-US" sz="1200" dirty="0"/>
              </a:p>
            </p:txBody>
          </p: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B4935C94-7E6F-F3D8-DC18-D4944227DBE0}"/>
                  </a:ext>
                </a:extLst>
              </p:cNvPr>
              <p:cNvSpPr txBox="1"/>
              <p:nvPr/>
            </p:nvSpPr>
            <p:spPr>
              <a:xfrm rot="17523636">
                <a:off x="2820865" y="3506835"/>
                <a:ext cx="539546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:40</a:t>
                </a:r>
                <a:endParaRPr lang="en-US" sz="1200" dirty="0"/>
              </a:p>
            </p:txBody>
          </p: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16C25944-3B89-26B9-1F4A-9979DD1C319A}"/>
                  </a:ext>
                </a:extLst>
              </p:cNvPr>
              <p:cNvSpPr txBox="1"/>
              <p:nvPr/>
            </p:nvSpPr>
            <p:spPr>
              <a:xfrm rot="17523636">
                <a:off x="3050548" y="3529192"/>
                <a:ext cx="539546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:60</a:t>
                </a:r>
                <a:endParaRPr lang="en-US" sz="1200" dirty="0"/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D7670F14-185B-E641-072B-39C8D1A2FD15}"/>
                  </a:ext>
                </a:extLst>
              </p:cNvPr>
              <p:cNvSpPr txBox="1"/>
              <p:nvPr/>
            </p:nvSpPr>
            <p:spPr>
              <a:xfrm rot="17523636">
                <a:off x="3280232" y="3529190"/>
                <a:ext cx="539546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:80</a:t>
                </a:r>
                <a:endParaRPr lang="en-US" sz="1200" dirty="0"/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FBF4945C-4D5B-D4EB-15A4-F9488B96993B}"/>
                  </a:ext>
                </a:extLst>
              </p:cNvPr>
              <p:cNvSpPr txBox="1"/>
              <p:nvPr/>
            </p:nvSpPr>
            <p:spPr>
              <a:xfrm rot="17523636">
                <a:off x="3469827" y="3476447"/>
                <a:ext cx="539546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A</a:t>
                </a:r>
                <a:endParaRPr lang="en-US" sz="1200" dirty="0"/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F227D7C3-09E3-E0D4-1E8A-F8518F9CEAE6}"/>
                  </a:ext>
                </a:extLst>
              </p:cNvPr>
              <p:cNvSpPr txBox="1"/>
              <p:nvPr/>
            </p:nvSpPr>
            <p:spPr>
              <a:xfrm>
                <a:off x="4392646" y="3051959"/>
                <a:ext cx="508473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4 h</a:t>
                </a:r>
              </a:p>
            </p:txBody>
          </p: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267C2FFB-D6BE-A3C6-2EC8-6D2DC26CABEE}"/>
                  </a:ext>
                </a:extLst>
              </p:cNvPr>
              <p:cNvSpPr txBox="1"/>
              <p:nvPr/>
            </p:nvSpPr>
            <p:spPr>
              <a:xfrm rot="17813602">
                <a:off x="3995166" y="3437571"/>
                <a:ext cx="646658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TRL</a:t>
                </a:r>
                <a:endParaRPr lang="en-US" sz="1200" dirty="0"/>
              </a:p>
            </p:txBody>
          </p: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9684A903-7432-8F97-5E61-024656F3D2D4}"/>
                  </a:ext>
                </a:extLst>
              </p:cNvPr>
              <p:cNvSpPr txBox="1"/>
              <p:nvPr/>
            </p:nvSpPr>
            <p:spPr>
              <a:xfrm rot="17523636">
                <a:off x="4278404" y="3496563"/>
                <a:ext cx="539546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:40</a:t>
                </a:r>
                <a:endParaRPr lang="en-US" sz="1200" dirty="0"/>
              </a:p>
            </p:txBody>
          </p:sp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84003E5D-2549-CAD2-B8F8-211A1D6BDB8C}"/>
                  </a:ext>
                </a:extLst>
              </p:cNvPr>
              <p:cNvSpPr txBox="1"/>
              <p:nvPr/>
            </p:nvSpPr>
            <p:spPr>
              <a:xfrm rot="17523636">
                <a:off x="4508087" y="3474676"/>
                <a:ext cx="539546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:60</a:t>
                </a:r>
                <a:endParaRPr lang="en-US" sz="1200" dirty="0"/>
              </a:p>
            </p:txBody>
          </p: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4289DC1B-A357-8620-1F04-C875164A22A7}"/>
                  </a:ext>
                </a:extLst>
              </p:cNvPr>
              <p:cNvSpPr txBox="1"/>
              <p:nvPr/>
            </p:nvSpPr>
            <p:spPr>
              <a:xfrm rot="17523636">
                <a:off x="4737771" y="3459926"/>
                <a:ext cx="539546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:80</a:t>
                </a:r>
                <a:endParaRPr lang="en-US" sz="1200" dirty="0"/>
              </a:p>
            </p:txBody>
          </p: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D0068770-0FCE-88C3-910E-F459A0B8843F}"/>
                  </a:ext>
                </a:extLst>
              </p:cNvPr>
              <p:cNvSpPr txBox="1"/>
              <p:nvPr/>
            </p:nvSpPr>
            <p:spPr>
              <a:xfrm rot="17523636">
                <a:off x="4927366" y="3407183"/>
                <a:ext cx="539546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A</a:t>
                </a:r>
                <a:endParaRPr lang="en-US" sz="1200" dirty="0"/>
              </a:p>
            </p:txBody>
          </p:sp>
        </p:grpSp>
        <p:grpSp>
          <p:nvGrpSpPr>
            <p:cNvPr id="37" name="Group 36">
              <a:extLst>
                <a:ext uri="{FF2B5EF4-FFF2-40B4-BE49-F238E27FC236}">
                  <a16:creationId xmlns:a16="http://schemas.microsoft.com/office/drawing/2014/main" id="{7F41F377-CEA8-99BE-E71B-71D83CF2BC6A}"/>
                </a:ext>
              </a:extLst>
            </p:cNvPr>
            <p:cNvGrpSpPr/>
            <p:nvPr/>
          </p:nvGrpSpPr>
          <p:grpSpPr>
            <a:xfrm>
              <a:off x="8229091" y="2953231"/>
              <a:ext cx="2613182" cy="921972"/>
              <a:chOff x="8229091" y="2953231"/>
              <a:chExt cx="2613182" cy="921972"/>
            </a:xfrm>
          </p:grpSpPr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1CDB86D5-2EB3-C3B3-C452-FF6B3EC464BC}"/>
                  </a:ext>
                </a:extLst>
              </p:cNvPr>
              <p:cNvSpPr txBox="1"/>
              <p:nvPr/>
            </p:nvSpPr>
            <p:spPr>
              <a:xfrm>
                <a:off x="8526170" y="2953231"/>
                <a:ext cx="508473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4 h</a:t>
                </a:r>
              </a:p>
            </p:txBody>
          </p: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1F1FD26E-AA7C-E357-2C9F-C92707B3FD9C}"/>
                  </a:ext>
                </a:extLst>
              </p:cNvPr>
              <p:cNvSpPr txBox="1"/>
              <p:nvPr/>
            </p:nvSpPr>
            <p:spPr>
              <a:xfrm rot="17813602">
                <a:off x="8044262" y="3413374"/>
                <a:ext cx="646658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TRL</a:t>
                </a:r>
                <a:endParaRPr lang="en-US" sz="1200" dirty="0"/>
              </a:p>
            </p:txBody>
          </p:sp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B61A68E9-4BC5-53A4-D921-98A87687A282}"/>
                  </a:ext>
                </a:extLst>
              </p:cNvPr>
              <p:cNvSpPr txBox="1"/>
              <p:nvPr/>
            </p:nvSpPr>
            <p:spPr>
              <a:xfrm rot="17523636">
                <a:off x="8327500" y="3413374"/>
                <a:ext cx="539546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:40</a:t>
                </a:r>
                <a:endParaRPr lang="en-US" sz="1200" dirty="0"/>
              </a:p>
            </p:txBody>
          </p:sp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4E61AB79-DEB5-B692-C911-F5F53ACB67D2}"/>
                  </a:ext>
                </a:extLst>
              </p:cNvPr>
              <p:cNvSpPr txBox="1"/>
              <p:nvPr/>
            </p:nvSpPr>
            <p:spPr>
              <a:xfrm rot="17523636">
                <a:off x="8557183" y="3435731"/>
                <a:ext cx="539546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:60</a:t>
                </a:r>
                <a:endParaRPr lang="en-US" sz="1200" dirty="0"/>
              </a:p>
            </p:txBody>
          </p:sp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3935A4E6-F183-369F-46DD-8549E13D2132}"/>
                  </a:ext>
                </a:extLst>
              </p:cNvPr>
              <p:cNvSpPr txBox="1"/>
              <p:nvPr/>
            </p:nvSpPr>
            <p:spPr>
              <a:xfrm rot="17523636">
                <a:off x="8786867" y="3435729"/>
                <a:ext cx="539546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:80</a:t>
                </a:r>
                <a:endParaRPr lang="en-US" sz="1200" dirty="0"/>
              </a:p>
            </p:txBody>
          </p:sp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02581244-4E9E-75A5-7AFB-2FE09F655D94}"/>
                  </a:ext>
                </a:extLst>
              </p:cNvPr>
              <p:cNvSpPr txBox="1"/>
              <p:nvPr/>
            </p:nvSpPr>
            <p:spPr>
              <a:xfrm rot="17523636">
                <a:off x="8976462" y="3382986"/>
                <a:ext cx="539546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A</a:t>
                </a:r>
                <a:endParaRPr lang="en-US" sz="1200" dirty="0"/>
              </a:p>
            </p:txBody>
          </p:sp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3C153E25-F701-D14D-0577-EE43B5FB5799}"/>
                  </a:ext>
                </a:extLst>
              </p:cNvPr>
              <p:cNvSpPr txBox="1"/>
              <p:nvPr/>
            </p:nvSpPr>
            <p:spPr>
              <a:xfrm>
                <a:off x="9899281" y="2958498"/>
                <a:ext cx="508473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4 h</a:t>
                </a:r>
              </a:p>
            </p:txBody>
          </p:sp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839F8BC9-0909-290F-82F1-31E259086DDE}"/>
                  </a:ext>
                </a:extLst>
              </p:cNvPr>
              <p:cNvSpPr txBox="1"/>
              <p:nvPr/>
            </p:nvSpPr>
            <p:spPr>
              <a:xfrm rot="17813602">
                <a:off x="9501801" y="3344110"/>
                <a:ext cx="646658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TRL</a:t>
                </a:r>
                <a:endParaRPr lang="en-US" sz="1200" dirty="0"/>
              </a:p>
            </p:txBody>
          </p:sp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3978667D-2FA2-3E3E-EE1E-0CCBCDBED5E5}"/>
                  </a:ext>
                </a:extLst>
              </p:cNvPr>
              <p:cNvSpPr txBox="1"/>
              <p:nvPr/>
            </p:nvSpPr>
            <p:spPr>
              <a:xfrm rot="17523636">
                <a:off x="9785039" y="3403102"/>
                <a:ext cx="539546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:40</a:t>
                </a:r>
                <a:endParaRPr lang="en-US" sz="1200" dirty="0"/>
              </a:p>
            </p:txBody>
          </p:sp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DD20CD4C-F2B6-4D71-B10B-80F2DF2B448D}"/>
                  </a:ext>
                </a:extLst>
              </p:cNvPr>
              <p:cNvSpPr txBox="1"/>
              <p:nvPr/>
            </p:nvSpPr>
            <p:spPr>
              <a:xfrm rot="17523636">
                <a:off x="10014722" y="3381215"/>
                <a:ext cx="539546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:60</a:t>
                </a:r>
                <a:endParaRPr lang="en-US" sz="1200" dirty="0"/>
              </a:p>
            </p:txBody>
          </p:sp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F3F2B851-5446-3008-3D48-53D87096555D}"/>
                  </a:ext>
                </a:extLst>
              </p:cNvPr>
              <p:cNvSpPr txBox="1"/>
              <p:nvPr/>
            </p:nvSpPr>
            <p:spPr>
              <a:xfrm rot="17523636">
                <a:off x="10244406" y="3366465"/>
                <a:ext cx="539546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:80</a:t>
                </a:r>
                <a:endParaRPr lang="en-US" sz="1200" dirty="0"/>
              </a:p>
            </p:txBody>
          </p:sp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A415B5F5-F817-78DC-0F45-E4009FDE5D63}"/>
                  </a:ext>
                </a:extLst>
              </p:cNvPr>
              <p:cNvSpPr txBox="1"/>
              <p:nvPr/>
            </p:nvSpPr>
            <p:spPr>
              <a:xfrm rot="17523636">
                <a:off x="10434001" y="3313722"/>
                <a:ext cx="539546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A</a:t>
                </a:r>
                <a:endParaRPr lang="en-US" sz="1200" dirty="0"/>
              </a:p>
            </p:txBody>
          </p:sp>
        </p:grpSp>
        <p:sp>
          <p:nvSpPr>
            <p:cNvPr id="39" name="Subtitle 2">
              <a:extLst>
                <a:ext uri="{FF2B5EF4-FFF2-40B4-BE49-F238E27FC236}">
                  <a16:creationId xmlns:a16="http://schemas.microsoft.com/office/drawing/2014/main" id="{96B7046B-45CC-6E54-D980-5B4D21AFC90A}"/>
                </a:ext>
              </a:extLst>
            </p:cNvPr>
            <p:cNvSpPr txBox="1">
              <a:spLocks/>
            </p:cNvSpPr>
            <p:nvPr/>
          </p:nvSpPr>
          <p:spPr>
            <a:xfrm>
              <a:off x="742413" y="5761584"/>
              <a:ext cx="8733505" cy="606300"/>
            </a:xfrm>
            <a:prstGeom prst="rect">
              <a:avLst/>
            </a:prstGeom>
          </p:spPr>
          <p:txBody>
            <a:bodyPr>
              <a:normAutofit fontScale="85000" lnSpcReduction="10000"/>
            </a:bodyPr>
            <a:lstStyle>
              <a:lvl1pPr marL="228600" indent="-228600" algn="l" defTabSz="914400" rtl="0" eaLnBrk="1" latinLnBrk="0" hangingPunct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6858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430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6002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0574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5146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9718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4290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8862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indent="0">
                <a:buNone/>
              </a:pPr>
              <a:r>
                <a:rPr lang="en-US" b="1" dirty="0"/>
                <a:t>Figure S2: </a:t>
              </a:r>
              <a:r>
                <a:rPr lang="en-US" dirty="0"/>
                <a:t>Original blots of Tubulin and PI3K protein expression</a:t>
              </a:r>
            </a:p>
          </p:txBody>
        </p:sp>
        <p:pic>
          <p:nvPicPr>
            <p:cNvPr id="1026" name="Picture 2" descr="_image_0">
              <a:extLst>
                <a:ext uri="{FF2B5EF4-FFF2-40B4-BE49-F238E27FC236}">
                  <a16:creationId xmlns:a16="http://schemas.microsoft.com/office/drawing/2014/main" id="{1C5B399B-11EB-17EC-BC6A-EE804B3D4522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1262" r="43085"/>
            <a:stretch>
              <a:fillRect/>
            </a:stretch>
          </p:blipFill>
          <p:spPr bwMode="auto">
            <a:xfrm>
              <a:off x="289844" y="1420332"/>
              <a:ext cx="902039" cy="387880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43" name="Group 42">
              <a:extLst>
                <a:ext uri="{FF2B5EF4-FFF2-40B4-BE49-F238E27FC236}">
                  <a16:creationId xmlns:a16="http://schemas.microsoft.com/office/drawing/2014/main" id="{F7AFE2A6-2D39-56F4-DA01-BD03DA3537F3}"/>
                </a:ext>
              </a:extLst>
            </p:cNvPr>
            <p:cNvGrpSpPr/>
            <p:nvPr/>
          </p:nvGrpSpPr>
          <p:grpSpPr>
            <a:xfrm>
              <a:off x="1757104" y="3761969"/>
              <a:ext cx="863575" cy="276999"/>
              <a:chOff x="1727608" y="3776717"/>
              <a:chExt cx="863575" cy="276999"/>
            </a:xfrm>
          </p:grpSpPr>
          <p:sp>
            <p:nvSpPr>
              <p:cNvPr id="40" name="TextBox 39">
                <a:extLst>
                  <a:ext uri="{FF2B5EF4-FFF2-40B4-BE49-F238E27FC236}">
                    <a16:creationId xmlns:a16="http://schemas.microsoft.com/office/drawing/2014/main" id="{B2881404-6691-8CE7-19E6-26BC7F82062F}"/>
                  </a:ext>
                </a:extLst>
              </p:cNvPr>
              <p:cNvSpPr txBox="1"/>
              <p:nvPr/>
            </p:nvSpPr>
            <p:spPr>
              <a:xfrm>
                <a:off x="1727608" y="3776717"/>
                <a:ext cx="64953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5 </a:t>
                </a:r>
                <a:r>
                  <a:rPr lang="en-US" sz="12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42" name="Straight Arrow Connector 41">
                <a:extLst>
                  <a:ext uri="{FF2B5EF4-FFF2-40B4-BE49-F238E27FC236}">
                    <a16:creationId xmlns:a16="http://schemas.microsoft.com/office/drawing/2014/main" id="{3B35A288-F1C9-AA8A-74F2-BB17D8D1B64E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377145" y="3944712"/>
                <a:ext cx="214038" cy="1"/>
              </a:xfrm>
              <a:prstGeom prst="straightConnector1">
                <a:avLst/>
              </a:prstGeom>
              <a:ln w="28575">
                <a:tailEnd type="triangle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44" name="Group 43">
              <a:extLst>
                <a:ext uri="{FF2B5EF4-FFF2-40B4-BE49-F238E27FC236}">
                  <a16:creationId xmlns:a16="http://schemas.microsoft.com/office/drawing/2014/main" id="{17872D96-EFB7-3F6E-BD6F-8DF21689B1AE}"/>
                </a:ext>
              </a:extLst>
            </p:cNvPr>
            <p:cNvGrpSpPr/>
            <p:nvPr/>
          </p:nvGrpSpPr>
          <p:grpSpPr>
            <a:xfrm>
              <a:off x="7246061" y="3694325"/>
              <a:ext cx="863575" cy="276999"/>
              <a:chOff x="1727608" y="3776717"/>
              <a:chExt cx="863575" cy="276999"/>
            </a:xfrm>
          </p:grpSpPr>
          <p:sp>
            <p:nvSpPr>
              <p:cNvPr id="45" name="TextBox 44">
                <a:extLst>
                  <a:ext uri="{FF2B5EF4-FFF2-40B4-BE49-F238E27FC236}">
                    <a16:creationId xmlns:a16="http://schemas.microsoft.com/office/drawing/2014/main" id="{F400C066-B958-271A-8850-3907503D429F}"/>
                  </a:ext>
                </a:extLst>
              </p:cNvPr>
              <p:cNvSpPr txBox="1"/>
              <p:nvPr/>
            </p:nvSpPr>
            <p:spPr>
              <a:xfrm>
                <a:off x="1727608" y="3776717"/>
                <a:ext cx="64953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5 </a:t>
                </a:r>
                <a:r>
                  <a:rPr lang="en-US" sz="12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46" name="Straight Arrow Connector 45">
                <a:extLst>
                  <a:ext uri="{FF2B5EF4-FFF2-40B4-BE49-F238E27FC236}">
                    <a16:creationId xmlns:a16="http://schemas.microsoft.com/office/drawing/2014/main" id="{3299A8FA-84FC-75E4-2CC9-CEC262E2ADC6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377145" y="3944712"/>
                <a:ext cx="214038" cy="1"/>
              </a:xfrm>
              <a:prstGeom prst="straightConnector1">
                <a:avLst/>
              </a:prstGeom>
              <a:ln w="28575">
                <a:tailEnd type="triangle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16927829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E343736-66E3-F7D0-F284-B7EB97546C5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Group 9">
            <a:extLst>
              <a:ext uri="{FF2B5EF4-FFF2-40B4-BE49-F238E27FC236}">
                <a16:creationId xmlns:a16="http://schemas.microsoft.com/office/drawing/2014/main" id="{01929EF4-B31D-2F2F-BC6C-D99FECC1652C}"/>
              </a:ext>
            </a:extLst>
          </p:cNvPr>
          <p:cNvGrpSpPr/>
          <p:nvPr/>
        </p:nvGrpSpPr>
        <p:grpSpPr>
          <a:xfrm>
            <a:off x="289844" y="990313"/>
            <a:ext cx="11192313" cy="5377571"/>
            <a:chOff x="289844" y="990313"/>
            <a:chExt cx="11192313" cy="5377571"/>
          </a:xfrm>
        </p:grpSpPr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EFF248D2-DD34-3623-303A-BE5C8E710E7E}"/>
                </a:ext>
              </a:extLst>
            </p:cNvPr>
            <p:cNvSpPr txBox="1"/>
            <p:nvPr/>
          </p:nvSpPr>
          <p:spPr>
            <a:xfrm>
              <a:off x="3341586" y="990313"/>
              <a:ext cx="6908543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800" b="1" dirty="0"/>
                <a:t>Tubulin						p-AKT</a:t>
              </a:r>
              <a:endParaRPr lang="en-US" dirty="0"/>
            </a:p>
          </p:txBody>
        </p:sp>
        <p:pic>
          <p:nvPicPr>
            <p:cNvPr id="8" name="Picture 7" descr="A close-up of a line&#10;&#10;AI-generated content may be incorrect.">
              <a:extLst>
                <a:ext uri="{FF2B5EF4-FFF2-40B4-BE49-F238E27FC236}">
                  <a16:creationId xmlns:a16="http://schemas.microsoft.com/office/drawing/2014/main" id="{7A38E0E9-C74E-24E5-5E31-9713A4AFAC6C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717909" y="1547665"/>
              <a:ext cx="4686300" cy="3670300"/>
            </a:xfrm>
            <a:prstGeom prst="rect">
              <a:avLst/>
            </a:prstGeom>
          </p:spPr>
        </p:pic>
        <p:pic>
          <p:nvPicPr>
            <p:cNvPr id="3" name="Picture 2" descr="A close-up of a test&#10;&#10;AI-generated content may be incorrect.">
              <a:extLst>
                <a:ext uri="{FF2B5EF4-FFF2-40B4-BE49-F238E27FC236}">
                  <a16:creationId xmlns:a16="http://schemas.microsoft.com/office/drawing/2014/main" id="{2849503D-D769-05F3-4CDC-3398F770981A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795857" y="1522265"/>
              <a:ext cx="4686300" cy="3695700"/>
            </a:xfrm>
            <a:prstGeom prst="rect">
              <a:avLst/>
            </a:prstGeom>
          </p:spPr>
        </p:pic>
        <p:grpSp>
          <p:nvGrpSpPr>
            <p:cNvPr id="32" name="Group 31">
              <a:extLst>
                <a:ext uri="{FF2B5EF4-FFF2-40B4-BE49-F238E27FC236}">
                  <a16:creationId xmlns:a16="http://schemas.microsoft.com/office/drawing/2014/main" id="{026B3816-FB60-C48B-937F-578E130AF8A4}"/>
                </a:ext>
              </a:extLst>
            </p:cNvPr>
            <p:cNvGrpSpPr/>
            <p:nvPr/>
          </p:nvGrpSpPr>
          <p:grpSpPr>
            <a:xfrm>
              <a:off x="2722456" y="3003357"/>
              <a:ext cx="2613182" cy="965307"/>
              <a:chOff x="2722456" y="3003357"/>
              <a:chExt cx="2613182" cy="965307"/>
            </a:xfrm>
          </p:grpSpPr>
          <p:sp>
            <p:nvSpPr>
              <p:cNvPr id="4" name="TextBox 3">
                <a:extLst>
                  <a:ext uri="{FF2B5EF4-FFF2-40B4-BE49-F238E27FC236}">
                    <a16:creationId xmlns:a16="http://schemas.microsoft.com/office/drawing/2014/main" id="{EA153057-B7CF-1572-0DFD-D9F84D9525F8}"/>
                  </a:ext>
                </a:extLst>
              </p:cNvPr>
              <p:cNvSpPr txBox="1"/>
              <p:nvPr/>
            </p:nvSpPr>
            <p:spPr>
              <a:xfrm>
                <a:off x="2931773" y="3003357"/>
                <a:ext cx="508473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4 h</a:t>
                </a:r>
              </a:p>
            </p:txBody>
          </p:sp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83B951EE-C199-AEE3-E633-5A539EE2C289}"/>
                  </a:ext>
                </a:extLst>
              </p:cNvPr>
              <p:cNvSpPr txBox="1"/>
              <p:nvPr/>
            </p:nvSpPr>
            <p:spPr>
              <a:xfrm rot="17813602">
                <a:off x="2537627" y="3506835"/>
                <a:ext cx="646658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TRL</a:t>
                </a:r>
                <a:endParaRPr lang="en-US" sz="1200" dirty="0"/>
              </a:p>
            </p:txBody>
          </p:sp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D1132EFD-32A6-E386-5B59-450F1B2E0E52}"/>
                  </a:ext>
                </a:extLst>
              </p:cNvPr>
              <p:cNvSpPr txBox="1"/>
              <p:nvPr/>
            </p:nvSpPr>
            <p:spPr>
              <a:xfrm rot="17523636">
                <a:off x="2820865" y="3506835"/>
                <a:ext cx="539546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:40</a:t>
                </a:r>
                <a:endParaRPr lang="en-US" sz="1200" dirty="0"/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788AB0AA-FEC6-C754-082D-86B7B0AE55AD}"/>
                  </a:ext>
                </a:extLst>
              </p:cNvPr>
              <p:cNvSpPr txBox="1"/>
              <p:nvPr/>
            </p:nvSpPr>
            <p:spPr>
              <a:xfrm rot="17523636">
                <a:off x="3050548" y="3529192"/>
                <a:ext cx="539546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:60</a:t>
                </a:r>
                <a:endParaRPr lang="en-US" sz="1200" dirty="0"/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A2743D46-C7CC-B462-98BD-D85C4496F430}"/>
                  </a:ext>
                </a:extLst>
              </p:cNvPr>
              <p:cNvSpPr txBox="1"/>
              <p:nvPr/>
            </p:nvSpPr>
            <p:spPr>
              <a:xfrm rot="17523636">
                <a:off x="3280232" y="3529190"/>
                <a:ext cx="539546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:80</a:t>
                </a:r>
                <a:endParaRPr lang="en-US" sz="1200" dirty="0"/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1B0D051F-2CBF-A742-6FEE-387BACA85A72}"/>
                  </a:ext>
                </a:extLst>
              </p:cNvPr>
              <p:cNvSpPr txBox="1"/>
              <p:nvPr/>
            </p:nvSpPr>
            <p:spPr>
              <a:xfrm rot="17523636">
                <a:off x="3469827" y="3476447"/>
                <a:ext cx="539546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A</a:t>
                </a:r>
                <a:endParaRPr lang="en-US" sz="1200" dirty="0"/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00CE84F2-85EC-7204-344F-F07E8483EF5E}"/>
                  </a:ext>
                </a:extLst>
              </p:cNvPr>
              <p:cNvSpPr txBox="1"/>
              <p:nvPr/>
            </p:nvSpPr>
            <p:spPr>
              <a:xfrm>
                <a:off x="4392646" y="3051959"/>
                <a:ext cx="508473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4 h</a:t>
                </a:r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E8AE4980-CCCA-4C9F-5042-FB6C423B439B}"/>
                  </a:ext>
                </a:extLst>
              </p:cNvPr>
              <p:cNvSpPr txBox="1"/>
              <p:nvPr/>
            </p:nvSpPr>
            <p:spPr>
              <a:xfrm rot="17813602">
                <a:off x="3995166" y="3437571"/>
                <a:ext cx="646658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TRL</a:t>
                </a:r>
                <a:endParaRPr lang="en-US" sz="1200" dirty="0"/>
              </a:p>
            </p:txBody>
          </p: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69508074-D684-DD90-7AB8-42054F6CFB2C}"/>
                  </a:ext>
                </a:extLst>
              </p:cNvPr>
              <p:cNvSpPr txBox="1"/>
              <p:nvPr/>
            </p:nvSpPr>
            <p:spPr>
              <a:xfrm rot="17523636">
                <a:off x="4278404" y="3496563"/>
                <a:ext cx="539546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:40</a:t>
                </a:r>
                <a:endParaRPr lang="en-US" sz="1200" dirty="0"/>
              </a:p>
            </p:txBody>
          </p: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682C9359-554B-003B-30A2-D086DCBDED6C}"/>
                  </a:ext>
                </a:extLst>
              </p:cNvPr>
              <p:cNvSpPr txBox="1"/>
              <p:nvPr/>
            </p:nvSpPr>
            <p:spPr>
              <a:xfrm rot="17523636">
                <a:off x="4508087" y="3474676"/>
                <a:ext cx="539546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:60</a:t>
                </a:r>
                <a:endParaRPr lang="en-US" sz="1200" dirty="0"/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3DCE8999-24F4-7FD5-49E8-A314B4A01EC6}"/>
                  </a:ext>
                </a:extLst>
              </p:cNvPr>
              <p:cNvSpPr txBox="1"/>
              <p:nvPr/>
            </p:nvSpPr>
            <p:spPr>
              <a:xfrm rot="17523636">
                <a:off x="4737771" y="3459926"/>
                <a:ext cx="539546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:80</a:t>
                </a:r>
                <a:endParaRPr lang="en-US" sz="1200" dirty="0"/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8311CBA0-FA52-01E4-DF27-065B3FC66061}"/>
                  </a:ext>
                </a:extLst>
              </p:cNvPr>
              <p:cNvSpPr txBox="1"/>
              <p:nvPr/>
            </p:nvSpPr>
            <p:spPr>
              <a:xfrm rot="17523636">
                <a:off x="4927366" y="3407183"/>
                <a:ext cx="539546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A</a:t>
                </a:r>
                <a:endParaRPr lang="en-US" sz="1200" dirty="0"/>
              </a:p>
            </p:txBody>
          </p:sp>
        </p:grpSp>
        <p:grpSp>
          <p:nvGrpSpPr>
            <p:cNvPr id="19" name="Group 18">
              <a:extLst>
                <a:ext uri="{FF2B5EF4-FFF2-40B4-BE49-F238E27FC236}">
                  <a16:creationId xmlns:a16="http://schemas.microsoft.com/office/drawing/2014/main" id="{D60F3EA3-2D46-798F-AC92-9EB920393464}"/>
                </a:ext>
              </a:extLst>
            </p:cNvPr>
            <p:cNvGrpSpPr/>
            <p:nvPr/>
          </p:nvGrpSpPr>
          <p:grpSpPr>
            <a:xfrm>
              <a:off x="7681192" y="2289280"/>
              <a:ext cx="2613182" cy="921972"/>
              <a:chOff x="8229091" y="2953231"/>
              <a:chExt cx="2613182" cy="921972"/>
            </a:xfrm>
          </p:grpSpPr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318CF925-EA62-2E56-B570-714994EAD318}"/>
                  </a:ext>
                </a:extLst>
              </p:cNvPr>
              <p:cNvSpPr txBox="1"/>
              <p:nvPr/>
            </p:nvSpPr>
            <p:spPr>
              <a:xfrm>
                <a:off x="8526170" y="2953231"/>
                <a:ext cx="508473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4 h</a:t>
                </a:r>
              </a:p>
            </p:txBody>
          </p: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DCB02A0D-08C4-4F6A-1705-3D5D036D2C98}"/>
                  </a:ext>
                </a:extLst>
              </p:cNvPr>
              <p:cNvSpPr txBox="1"/>
              <p:nvPr/>
            </p:nvSpPr>
            <p:spPr>
              <a:xfrm rot="17813602">
                <a:off x="8044262" y="3413374"/>
                <a:ext cx="646658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TRL</a:t>
                </a:r>
                <a:endParaRPr lang="en-US" sz="1200" dirty="0"/>
              </a:p>
            </p:txBody>
          </p:sp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AD0CF951-5820-F40C-B95E-20519B55953D}"/>
                  </a:ext>
                </a:extLst>
              </p:cNvPr>
              <p:cNvSpPr txBox="1"/>
              <p:nvPr/>
            </p:nvSpPr>
            <p:spPr>
              <a:xfrm rot="17523636">
                <a:off x="8327500" y="3413374"/>
                <a:ext cx="539546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:40</a:t>
                </a:r>
                <a:endParaRPr lang="en-US" sz="1200" dirty="0"/>
              </a:p>
            </p:txBody>
          </p: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FC71A626-B00F-ADE9-DD6B-41C957DB660A}"/>
                  </a:ext>
                </a:extLst>
              </p:cNvPr>
              <p:cNvSpPr txBox="1"/>
              <p:nvPr/>
            </p:nvSpPr>
            <p:spPr>
              <a:xfrm rot="17523636">
                <a:off x="8557183" y="3435731"/>
                <a:ext cx="539546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:60</a:t>
                </a:r>
                <a:endParaRPr lang="en-US" sz="1200" dirty="0"/>
              </a:p>
            </p:txBody>
          </p: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7732C51D-7C3E-0F06-CA8A-3314D56853F5}"/>
                  </a:ext>
                </a:extLst>
              </p:cNvPr>
              <p:cNvSpPr txBox="1"/>
              <p:nvPr/>
            </p:nvSpPr>
            <p:spPr>
              <a:xfrm rot="17523636">
                <a:off x="8786867" y="3435729"/>
                <a:ext cx="539546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:80</a:t>
                </a:r>
                <a:endParaRPr lang="en-US" sz="1200" dirty="0"/>
              </a:p>
            </p:txBody>
          </p:sp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69C4E91A-7079-6D22-9CA2-539A4BFEE7A1}"/>
                  </a:ext>
                </a:extLst>
              </p:cNvPr>
              <p:cNvSpPr txBox="1"/>
              <p:nvPr/>
            </p:nvSpPr>
            <p:spPr>
              <a:xfrm rot="17523636">
                <a:off x="8976462" y="3382986"/>
                <a:ext cx="539546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A</a:t>
                </a:r>
                <a:endParaRPr lang="en-US" sz="1200" dirty="0"/>
              </a:p>
            </p:txBody>
          </p: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54D7D47D-A470-0BC7-2ECD-C8C44E86A0B3}"/>
                  </a:ext>
                </a:extLst>
              </p:cNvPr>
              <p:cNvSpPr txBox="1"/>
              <p:nvPr/>
            </p:nvSpPr>
            <p:spPr>
              <a:xfrm>
                <a:off x="9899281" y="2958498"/>
                <a:ext cx="508473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4 h</a:t>
                </a:r>
              </a:p>
            </p:txBody>
          </p:sp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864389C7-B935-AF76-EF28-EFAAAD8A6CDC}"/>
                  </a:ext>
                </a:extLst>
              </p:cNvPr>
              <p:cNvSpPr txBox="1"/>
              <p:nvPr/>
            </p:nvSpPr>
            <p:spPr>
              <a:xfrm rot="17813602">
                <a:off x="9501801" y="3344110"/>
                <a:ext cx="646658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TRL</a:t>
                </a:r>
                <a:endParaRPr lang="en-US" sz="1200" dirty="0"/>
              </a:p>
            </p:txBody>
          </p:sp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D5DD0DCB-A0ED-057A-7B50-B9261C71B71B}"/>
                  </a:ext>
                </a:extLst>
              </p:cNvPr>
              <p:cNvSpPr txBox="1"/>
              <p:nvPr/>
            </p:nvSpPr>
            <p:spPr>
              <a:xfrm rot="17523636">
                <a:off x="9785039" y="3403102"/>
                <a:ext cx="539546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:40</a:t>
                </a:r>
                <a:endParaRPr lang="en-US" sz="1200" dirty="0"/>
              </a:p>
            </p:txBody>
          </p:sp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D5607631-601D-0885-1E1E-0D44B3528AA4}"/>
                  </a:ext>
                </a:extLst>
              </p:cNvPr>
              <p:cNvSpPr txBox="1"/>
              <p:nvPr/>
            </p:nvSpPr>
            <p:spPr>
              <a:xfrm rot="17523636">
                <a:off x="10014722" y="3381215"/>
                <a:ext cx="539546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:60</a:t>
                </a:r>
                <a:endParaRPr lang="en-US" sz="1200" dirty="0"/>
              </a:p>
            </p:txBody>
          </p:sp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6F0E3CB1-196C-448F-82DF-2846490B4516}"/>
                  </a:ext>
                </a:extLst>
              </p:cNvPr>
              <p:cNvSpPr txBox="1"/>
              <p:nvPr/>
            </p:nvSpPr>
            <p:spPr>
              <a:xfrm rot="17523636">
                <a:off x="10244406" y="3366465"/>
                <a:ext cx="539546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:80</a:t>
                </a:r>
                <a:endParaRPr lang="en-US" sz="1200" dirty="0"/>
              </a:p>
            </p:txBody>
          </p:sp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5327C308-AD76-36F6-102B-EBC9E401BC12}"/>
                  </a:ext>
                </a:extLst>
              </p:cNvPr>
              <p:cNvSpPr txBox="1"/>
              <p:nvPr/>
            </p:nvSpPr>
            <p:spPr>
              <a:xfrm rot="17523636">
                <a:off x="10434001" y="3313722"/>
                <a:ext cx="539546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A</a:t>
                </a:r>
                <a:endParaRPr lang="en-US" sz="1200" dirty="0"/>
              </a:p>
            </p:txBody>
          </p:sp>
        </p:grpSp>
        <p:grpSp>
          <p:nvGrpSpPr>
            <p:cNvPr id="33" name="Group 32">
              <a:extLst>
                <a:ext uri="{FF2B5EF4-FFF2-40B4-BE49-F238E27FC236}">
                  <a16:creationId xmlns:a16="http://schemas.microsoft.com/office/drawing/2014/main" id="{1B7EEB8F-66B8-19C2-EAE5-4B66F1118407}"/>
                </a:ext>
              </a:extLst>
            </p:cNvPr>
            <p:cNvGrpSpPr/>
            <p:nvPr/>
          </p:nvGrpSpPr>
          <p:grpSpPr>
            <a:xfrm>
              <a:off x="1757104" y="3761969"/>
              <a:ext cx="863575" cy="276999"/>
              <a:chOff x="1727608" y="3776717"/>
              <a:chExt cx="863575" cy="276999"/>
            </a:xfrm>
          </p:grpSpPr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CF2486A7-131E-1B90-16D6-F27718F27C7C}"/>
                  </a:ext>
                </a:extLst>
              </p:cNvPr>
              <p:cNvSpPr txBox="1"/>
              <p:nvPr/>
            </p:nvSpPr>
            <p:spPr>
              <a:xfrm>
                <a:off x="1727608" y="3776717"/>
                <a:ext cx="64953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5 </a:t>
                </a:r>
                <a:r>
                  <a:rPr lang="en-US" sz="12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35" name="Straight Arrow Connector 34">
                <a:extLst>
                  <a:ext uri="{FF2B5EF4-FFF2-40B4-BE49-F238E27FC236}">
                    <a16:creationId xmlns:a16="http://schemas.microsoft.com/office/drawing/2014/main" id="{F6353DA0-2A3A-0D99-19B0-83F429F491AF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377145" y="3944712"/>
                <a:ext cx="214038" cy="1"/>
              </a:xfrm>
              <a:prstGeom prst="straightConnector1">
                <a:avLst/>
              </a:prstGeom>
              <a:ln w="28575">
                <a:tailEnd type="triangle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pic>
          <p:nvPicPr>
            <p:cNvPr id="36" name="Picture 2" descr="_image_0">
              <a:extLst>
                <a:ext uri="{FF2B5EF4-FFF2-40B4-BE49-F238E27FC236}">
                  <a16:creationId xmlns:a16="http://schemas.microsoft.com/office/drawing/2014/main" id="{3526BA88-DBEB-BDE3-63DE-3204AD0E7722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1262" r="43085"/>
            <a:stretch>
              <a:fillRect/>
            </a:stretch>
          </p:blipFill>
          <p:spPr bwMode="auto">
            <a:xfrm>
              <a:off x="289844" y="1420332"/>
              <a:ext cx="902039" cy="387880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37" name="Group 36">
              <a:extLst>
                <a:ext uri="{FF2B5EF4-FFF2-40B4-BE49-F238E27FC236}">
                  <a16:creationId xmlns:a16="http://schemas.microsoft.com/office/drawing/2014/main" id="{594FD5FE-6AF9-91C6-6C9D-B2974809BFE4}"/>
                </a:ext>
              </a:extLst>
            </p:cNvPr>
            <p:cNvGrpSpPr/>
            <p:nvPr/>
          </p:nvGrpSpPr>
          <p:grpSpPr>
            <a:xfrm>
              <a:off x="6776717" y="3368335"/>
              <a:ext cx="863575" cy="276999"/>
              <a:chOff x="1727608" y="3776717"/>
              <a:chExt cx="863575" cy="276999"/>
            </a:xfrm>
          </p:grpSpPr>
          <p:sp>
            <p:nvSpPr>
              <p:cNvPr id="38" name="TextBox 37">
                <a:extLst>
                  <a:ext uri="{FF2B5EF4-FFF2-40B4-BE49-F238E27FC236}">
                    <a16:creationId xmlns:a16="http://schemas.microsoft.com/office/drawing/2014/main" id="{CC7AC1AE-A38B-6FB7-A84C-85CC9E862927}"/>
                  </a:ext>
                </a:extLst>
              </p:cNvPr>
              <p:cNvSpPr txBox="1"/>
              <p:nvPr/>
            </p:nvSpPr>
            <p:spPr>
              <a:xfrm>
                <a:off x="1727608" y="3776717"/>
                <a:ext cx="64953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0 </a:t>
                </a:r>
                <a:r>
                  <a:rPr lang="en-US" sz="12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39" name="Straight Arrow Connector 38">
                <a:extLst>
                  <a:ext uri="{FF2B5EF4-FFF2-40B4-BE49-F238E27FC236}">
                    <a16:creationId xmlns:a16="http://schemas.microsoft.com/office/drawing/2014/main" id="{ED8B9C1B-7DF1-7E2D-1640-2AB4C2FB275C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377145" y="3944712"/>
                <a:ext cx="214038" cy="1"/>
              </a:xfrm>
              <a:prstGeom prst="straightConnector1">
                <a:avLst/>
              </a:prstGeom>
              <a:ln w="28575">
                <a:tailEnd type="triangle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2" name="Subtitle 2">
              <a:extLst>
                <a:ext uri="{FF2B5EF4-FFF2-40B4-BE49-F238E27FC236}">
                  <a16:creationId xmlns:a16="http://schemas.microsoft.com/office/drawing/2014/main" id="{3566B987-3B3D-5B40-6B09-20E7E081081A}"/>
                </a:ext>
              </a:extLst>
            </p:cNvPr>
            <p:cNvSpPr txBox="1">
              <a:spLocks/>
            </p:cNvSpPr>
            <p:nvPr/>
          </p:nvSpPr>
          <p:spPr>
            <a:xfrm>
              <a:off x="742412" y="5761584"/>
              <a:ext cx="8608969" cy="606300"/>
            </a:xfrm>
            <a:prstGeom prst="rect">
              <a:avLst/>
            </a:prstGeom>
          </p:spPr>
          <p:txBody>
            <a:bodyPr>
              <a:noAutofit/>
            </a:bodyPr>
            <a:lstStyle>
              <a:lvl1pPr marL="228600" indent="-228600" algn="l" defTabSz="914400" rtl="0" eaLnBrk="1" latinLnBrk="0" hangingPunct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6858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430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6002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0574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5146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9718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4290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8862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indent="0">
                <a:buNone/>
              </a:pPr>
              <a:r>
                <a:rPr lang="en-US" sz="2400" b="1" dirty="0"/>
                <a:t>Figure S3: </a:t>
              </a:r>
              <a:r>
                <a:rPr lang="en-US" sz="2400" dirty="0"/>
                <a:t>Original blots of Tubulin and p-AKT protein expression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67136405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5C612F9-3855-8249-2D28-1D4BEF73F47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94F6625D-22F0-667F-3D76-7ABA37F1A0F4}"/>
              </a:ext>
            </a:extLst>
          </p:cNvPr>
          <p:cNvGrpSpPr/>
          <p:nvPr/>
        </p:nvGrpSpPr>
        <p:grpSpPr>
          <a:xfrm>
            <a:off x="289844" y="990313"/>
            <a:ext cx="11211978" cy="5377571"/>
            <a:chOff x="289844" y="990313"/>
            <a:chExt cx="11211978" cy="5377571"/>
          </a:xfrm>
        </p:grpSpPr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6F298608-6963-6727-12F7-B9BEFF6F7EE2}"/>
                </a:ext>
              </a:extLst>
            </p:cNvPr>
            <p:cNvSpPr txBox="1"/>
            <p:nvPr/>
          </p:nvSpPr>
          <p:spPr>
            <a:xfrm>
              <a:off x="3341586" y="990313"/>
              <a:ext cx="6908543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800" b="1" dirty="0"/>
                <a:t>Tubulin						AKT</a:t>
              </a:r>
              <a:endParaRPr lang="en-US" dirty="0"/>
            </a:p>
          </p:txBody>
        </p:sp>
        <p:pic>
          <p:nvPicPr>
            <p:cNvPr id="8" name="Picture 7" descr="A close-up of a line&#10;&#10;AI-generated content may be incorrect.">
              <a:extLst>
                <a:ext uri="{FF2B5EF4-FFF2-40B4-BE49-F238E27FC236}">
                  <a16:creationId xmlns:a16="http://schemas.microsoft.com/office/drawing/2014/main" id="{BC320611-09D3-94E1-3E4A-EA58983FF2F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717909" y="1547665"/>
              <a:ext cx="4686300" cy="3670300"/>
            </a:xfrm>
            <a:prstGeom prst="rect">
              <a:avLst/>
            </a:prstGeom>
          </p:spPr>
        </p:pic>
        <p:pic>
          <p:nvPicPr>
            <p:cNvPr id="4" name="Picture 3" descr="A close-up of a test&#10;&#10;AI-generated content may be incorrect.">
              <a:extLst>
                <a:ext uri="{FF2B5EF4-FFF2-40B4-BE49-F238E27FC236}">
                  <a16:creationId xmlns:a16="http://schemas.microsoft.com/office/drawing/2014/main" id="{72CC724B-8AE2-74F3-30A9-16ABD9FF02CC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815522" y="1522265"/>
              <a:ext cx="4686300" cy="3695700"/>
            </a:xfrm>
            <a:prstGeom prst="rect">
              <a:avLst/>
            </a:prstGeom>
          </p:spPr>
        </p:pic>
        <p:grpSp>
          <p:nvGrpSpPr>
            <p:cNvPr id="32" name="Group 31">
              <a:extLst>
                <a:ext uri="{FF2B5EF4-FFF2-40B4-BE49-F238E27FC236}">
                  <a16:creationId xmlns:a16="http://schemas.microsoft.com/office/drawing/2014/main" id="{A49A88B2-C198-6DCE-8436-02867D88F687}"/>
                </a:ext>
              </a:extLst>
            </p:cNvPr>
            <p:cNvGrpSpPr/>
            <p:nvPr/>
          </p:nvGrpSpPr>
          <p:grpSpPr>
            <a:xfrm>
              <a:off x="2722456" y="3003357"/>
              <a:ext cx="2613182" cy="965307"/>
              <a:chOff x="2722456" y="3003357"/>
              <a:chExt cx="2613182" cy="965307"/>
            </a:xfrm>
          </p:grpSpPr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95B99FC3-54E2-B39C-8363-D55F5684037C}"/>
                  </a:ext>
                </a:extLst>
              </p:cNvPr>
              <p:cNvSpPr txBox="1"/>
              <p:nvPr/>
            </p:nvSpPr>
            <p:spPr>
              <a:xfrm>
                <a:off x="2931773" y="3003357"/>
                <a:ext cx="508473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4 h</a:t>
                </a:r>
              </a:p>
            </p:txBody>
          </p:sp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65E01EF3-ABC3-88D0-A220-2F1B320F6F72}"/>
                  </a:ext>
                </a:extLst>
              </p:cNvPr>
              <p:cNvSpPr txBox="1"/>
              <p:nvPr/>
            </p:nvSpPr>
            <p:spPr>
              <a:xfrm rot="17813602">
                <a:off x="2537627" y="3506835"/>
                <a:ext cx="646658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TRL</a:t>
                </a:r>
                <a:endParaRPr lang="en-US" sz="1200" dirty="0"/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00AC8439-CBEE-2117-8247-2C6D6F4D206F}"/>
                  </a:ext>
                </a:extLst>
              </p:cNvPr>
              <p:cNvSpPr txBox="1"/>
              <p:nvPr/>
            </p:nvSpPr>
            <p:spPr>
              <a:xfrm rot="17523636">
                <a:off x="2820865" y="3506835"/>
                <a:ext cx="539546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:40</a:t>
                </a:r>
                <a:endParaRPr lang="en-US" sz="1200" dirty="0"/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1A297E6B-7F64-6260-4B0B-235F7563D584}"/>
                  </a:ext>
                </a:extLst>
              </p:cNvPr>
              <p:cNvSpPr txBox="1"/>
              <p:nvPr/>
            </p:nvSpPr>
            <p:spPr>
              <a:xfrm rot="17523636">
                <a:off x="3050548" y="3529192"/>
                <a:ext cx="539546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:60</a:t>
                </a:r>
                <a:endParaRPr lang="en-US" sz="1200" dirty="0"/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0B920A05-2A73-D7A0-822E-39C60935F984}"/>
                  </a:ext>
                </a:extLst>
              </p:cNvPr>
              <p:cNvSpPr txBox="1"/>
              <p:nvPr/>
            </p:nvSpPr>
            <p:spPr>
              <a:xfrm rot="17523636">
                <a:off x="3280232" y="3529190"/>
                <a:ext cx="539546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:80</a:t>
                </a:r>
                <a:endParaRPr lang="en-US" sz="1200" dirty="0"/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60BBC3CF-6E08-104A-1FBA-8898767BD629}"/>
                  </a:ext>
                </a:extLst>
              </p:cNvPr>
              <p:cNvSpPr txBox="1"/>
              <p:nvPr/>
            </p:nvSpPr>
            <p:spPr>
              <a:xfrm rot="17523636">
                <a:off x="3469827" y="3476447"/>
                <a:ext cx="539546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A</a:t>
                </a:r>
                <a:endParaRPr lang="en-US" sz="1200" dirty="0"/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98D08CFF-8A96-531C-77B1-343A6503EE97}"/>
                  </a:ext>
                </a:extLst>
              </p:cNvPr>
              <p:cNvSpPr txBox="1"/>
              <p:nvPr/>
            </p:nvSpPr>
            <p:spPr>
              <a:xfrm>
                <a:off x="4392646" y="3051959"/>
                <a:ext cx="508473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4 h</a:t>
                </a:r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993B3EC4-7464-E567-353F-92B7C77C9D15}"/>
                  </a:ext>
                </a:extLst>
              </p:cNvPr>
              <p:cNvSpPr txBox="1"/>
              <p:nvPr/>
            </p:nvSpPr>
            <p:spPr>
              <a:xfrm rot="17813602">
                <a:off x="3995166" y="3437571"/>
                <a:ext cx="646658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TRL</a:t>
                </a:r>
                <a:endParaRPr lang="en-US" sz="1200" dirty="0"/>
              </a:p>
            </p:txBody>
          </p: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0A1076E0-FE17-6D18-6DD4-03DC393C6DFC}"/>
                  </a:ext>
                </a:extLst>
              </p:cNvPr>
              <p:cNvSpPr txBox="1"/>
              <p:nvPr/>
            </p:nvSpPr>
            <p:spPr>
              <a:xfrm rot="17523636">
                <a:off x="4278404" y="3496563"/>
                <a:ext cx="539546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:40</a:t>
                </a:r>
                <a:endParaRPr lang="en-US" sz="1200" dirty="0"/>
              </a:p>
            </p:txBody>
          </p: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99C8CD3F-8EBB-CFBB-CF7F-E58EEEAE5282}"/>
                  </a:ext>
                </a:extLst>
              </p:cNvPr>
              <p:cNvSpPr txBox="1"/>
              <p:nvPr/>
            </p:nvSpPr>
            <p:spPr>
              <a:xfrm rot="17523636">
                <a:off x="4508087" y="3474676"/>
                <a:ext cx="539546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:60</a:t>
                </a:r>
                <a:endParaRPr lang="en-US" sz="1200" dirty="0"/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DE58DD0B-DF58-613E-B87D-DF1DAB347AC1}"/>
                  </a:ext>
                </a:extLst>
              </p:cNvPr>
              <p:cNvSpPr txBox="1"/>
              <p:nvPr/>
            </p:nvSpPr>
            <p:spPr>
              <a:xfrm rot="17523636">
                <a:off x="4737771" y="3459926"/>
                <a:ext cx="539546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:80</a:t>
                </a:r>
                <a:endParaRPr lang="en-US" sz="1200" dirty="0"/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EB7957DB-68FF-C56E-9F78-83CF155BA131}"/>
                  </a:ext>
                </a:extLst>
              </p:cNvPr>
              <p:cNvSpPr txBox="1"/>
              <p:nvPr/>
            </p:nvSpPr>
            <p:spPr>
              <a:xfrm rot="17523636">
                <a:off x="4927366" y="3407183"/>
                <a:ext cx="539546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A</a:t>
                </a:r>
                <a:endParaRPr lang="en-US" sz="1200" dirty="0"/>
              </a:p>
            </p:txBody>
          </p:sp>
        </p:grpSp>
        <p:grpSp>
          <p:nvGrpSpPr>
            <p:cNvPr id="19" name="Group 18">
              <a:extLst>
                <a:ext uri="{FF2B5EF4-FFF2-40B4-BE49-F238E27FC236}">
                  <a16:creationId xmlns:a16="http://schemas.microsoft.com/office/drawing/2014/main" id="{718F34F3-14DA-300F-8DFD-A3E7B6A06D81}"/>
                </a:ext>
              </a:extLst>
            </p:cNvPr>
            <p:cNvGrpSpPr/>
            <p:nvPr/>
          </p:nvGrpSpPr>
          <p:grpSpPr>
            <a:xfrm>
              <a:off x="8042124" y="2277425"/>
              <a:ext cx="2613182" cy="921972"/>
              <a:chOff x="8229091" y="2953231"/>
              <a:chExt cx="2613182" cy="921972"/>
            </a:xfrm>
          </p:grpSpPr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7E4F7D2D-C585-7A18-6F3D-2A76917064B5}"/>
                  </a:ext>
                </a:extLst>
              </p:cNvPr>
              <p:cNvSpPr txBox="1"/>
              <p:nvPr/>
            </p:nvSpPr>
            <p:spPr>
              <a:xfrm>
                <a:off x="8526170" y="2953231"/>
                <a:ext cx="508473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4 h</a:t>
                </a:r>
              </a:p>
            </p:txBody>
          </p: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4518C78F-63BC-E496-EB00-3572E5E61829}"/>
                  </a:ext>
                </a:extLst>
              </p:cNvPr>
              <p:cNvSpPr txBox="1"/>
              <p:nvPr/>
            </p:nvSpPr>
            <p:spPr>
              <a:xfrm rot="17813602">
                <a:off x="8044262" y="3413374"/>
                <a:ext cx="646658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TRL</a:t>
                </a:r>
                <a:endParaRPr lang="en-US" sz="1200" dirty="0"/>
              </a:p>
            </p:txBody>
          </p:sp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CDA73B86-B594-2EF4-36CE-1E6B90A0A06A}"/>
                  </a:ext>
                </a:extLst>
              </p:cNvPr>
              <p:cNvSpPr txBox="1"/>
              <p:nvPr/>
            </p:nvSpPr>
            <p:spPr>
              <a:xfrm rot="17523636">
                <a:off x="8356996" y="3413374"/>
                <a:ext cx="539546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:40</a:t>
                </a:r>
                <a:endParaRPr lang="en-US" sz="1200" dirty="0"/>
              </a:p>
            </p:txBody>
          </p: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A32BD54E-8CD7-428E-374D-EE3470C1AE67}"/>
                  </a:ext>
                </a:extLst>
              </p:cNvPr>
              <p:cNvSpPr txBox="1"/>
              <p:nvPr/>
            </p:nvSpPr>
            <p:spPr>
              <a:xfrm rot="17523636">
                <a:off x="8557183" y="3435731"/>
                <a:ext cx="539546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:60</a:t>
                </a:r>
                <a:endParaRPr lang="en-US" sz="1200" dirty="0"/>
              </a:p>
            </p:txBody>
          </p: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2B3E4FBF-39A4-7D56-9F41-CB8F2C2CC2C4}"/>
                  </a:ext>
                </a:extLst>
              </p:cNvPr>
              <p:cNvSpPr txBox="1"/>
              <p:nvPr/>
            </p:nvSpPr>
            <p:spPr>
              <a:xfrm rot="17523636">
                <a:off x="8772119" y="3435729"/>
                <a:ext cx="539546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:80</a:t>
                </a:r>
                <a:endParaRPr lang="en-US" sz="1200" dirty="0"/>
              </a:p>
            </p:txBody>
          </p:sp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AD59E749-CD75-9422-6484-806ED96817D3}"/>
                  </a:ext>
                </a:extLst>
              </p:cNvPr>
              <p:cNvSpPr txBox="1"/>
              <p:nvPr/>
            </p:nvSpPr>
            <p:spPr>
              <a:xfrm rot="17523636">
                <a:off x="8976462" y="3382986"/>
                <a:ext cx="539546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A</a:t>
                </a:r>
                <a:endParaRPr lang="en-US" sz="1200" dirty="0"/>
              </a:p>
            </p:txBody>
          </p: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83176106-DA60-79F5-D7E8-E541C442560E}"/>
                  </a:ext>
                </a:extLst>
              </p:cNvPr>
              <p:cNvSpPr txBox="1"/>
              <p:nvPr/>
            </p:nvSpPr>
            <p:spPr>
              <a:xfrm>
                <a:off x="9899281" y="2958498"/>
                <a:ext cx="508473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4 h</a:t>
                </a:r>
              </a:p>
            </p:txBody>
          </p:sp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56058E06-73A9-33C2-E2FF-DB2D7DDD78DD}"/>
                  </a:ext>
                </a:extLst>
              </p:cNvPr>
              <p:cNvSpPr txBox="1"/>
              <p:nvPr/>
            </p:nvSpPr>
            <p:spPr>
              <a:xfrm rot="17813602">
                <a:off x="9501801" y="3344110"/>
                <a:ext cx="646658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TRL</a:t>
                </a:r>
                <a:endParaRPr lang="en-US" sz="1200" dirty="0"/>
              </a:p>
            </p:txBody>
          </p:sp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79F27109-C1A6-91D3-7CD5-5B5F09391FBF}"/>
                  </a:ext>
                </a:extLst>
              </p:cNvPr>
              <p:cNvSpPr txBox="1"/>
              <p:nvPr/>
            </p:nvSpPr>
            <p:spPr>
              <a:xfrm rot="17523636">
                <a:off x="9785039" y="3403102"/>
                <a:ext cx="539546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:40</a:t>
                </a:r>
                <a:endParaRPr lang="en-US" sz="1200" dirty="0"/>
              </a:p>
            </p:txBody>
          </p:sp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A73B8701-13F0-28A8-5204-FB3FC8C4306D}"/>
                  </a:ext>
                </a:extLst>
              </p:cNvPr>
              <p:cNvSpPr txBox="1"/>
              <p:nvPr/>
            </p:nvSpPr>
            <p:spPr>
              <a:xfrm rot="17523636">
                <a:off x="10014722" y="3381215"/>
                <a:ext cx="539546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:60</a:t>
                </a:r>
                <a:endParaRPr lang="en-US" sz="1200" dirty="0"/>
              </a:p>
            </p:txBody>
          </p:sp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928B3535-9FFD-537C-CDCF-EC5225B1E666}"/>
                  </a:ext>
                </a:extLst>
              </p:cNvPr>
              <p:cNvSpPr txBox="1"/>
              <p:nvPr/>
            </p:nvSpPr>
            <p:spPr>
              <a:xfrm rot="17523636">
                <a:off x="10244406" y="3366465"/>
                <a:ext cx="539546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:80</a:t>
                </a:r>
                <a:endParaRPr lang="en-US" sz="1200" dirty="0"/>
              </a:p>
            </p:txBody>
          </p:sp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D0491E7B-36F9-B006-64E8-D00274C4ABCA}"/>
                  </a:ext>
                </a:extLst>
              </p:cNvPr>
              <p:cNvSpPr txBox="1"/>
              <p:nvPr/>
            </p:nvSpPr>
            <p:spPr>
              <a:xfrm rot="17523636">
                <a:off x="10434001" y="3313722"/>
                <a:ext cx="539546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A</a:t>
                </a:r>
                <a:endParaRPr lang="en-US" sz="1200" dirty="0"/>
              </a:p>
            </p:txBody>
          </p:sp>
        </p:grpSp>
        <p:pic>
          <p:nvPicPr>
            <p:cNvPr id="33" name="Picture 2" descr="_image_0">
              <a:extLst>
                <a:ext uri="{FF2B5EF4-FFF2-40B4-BE49-F238E27FC236}">
                  <a16:creationId xmlns:a16="http://schemas.microsoft.com/office/drawing/2014/main" id="{63194274-9A00-3D30-471B-806DCCEE47C3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1262" r="43085"/>
            <a:stretch>
              <a:fillRect/>
            </a:stretch>
          </p:blipFill>
          <p:spPr bwMode="auto">
            <a:xfrm>
              <a:off x="289844" y="1420332"/>
              <a:ext cx="902039" cy="387880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34" name="Group 33">
              <a:extLst>
                <a:ext uri="{FF2B5EF4-FFF2-40B4-BE49-F238E27FC236}">
                  <a16:creationId xmlns:a16="http://schemas.microsoft.com/office/drawing/2014/main" id="{61CDBD2A-5442-1247-04F6-00C36B7FBAB7}"/>
                </a:ext>
              </a:extLst>
            </p:cNvPr>
            <p:cNvGrpSpPr/>
            <p:nvPr/>
          </p:nvGrpSpPr>
          <p:grpSpPr>
            <a:xfrm>
              <a:off x="1757104" y="3761969"/>
              <a:ext cx="863575" cy="276999"/>
              <a:chOff x="1727608" y="3776717"/>
              <a:chExt cx="863575" cy="276999"/>
            </a:xfrm>
          </p:grpSpPr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E1DBD681-900E-6B8B-8F1E-7DDB75922C23}"/>
                  </a:ext>
                </a:extLst>
              </p:cNvPr>
              <p:cNvSpPr txBox="1"/>
              <p:nvPr/>
            </p:nvSpPr>
            <p:spPr>
              <a:xfrm>
                <a:off x="1727608" y="3776717"/>
                <a:ext cx="64953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5 </a:t>
                </a:r>
                <a:r>
                  <a:rPr lang="en-US" sz="12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36" name="Straight Arrow Connector 35">
                <a:extLst>
                  <a:ext uri="{FF2B5EF4-FFF2-40B4-BE49-F238E27FC236}">
                    <a16:creationId xmlns:a16="http://schemas.microsoft.com/office/drawing/2014/main" id="{C020C558-17FD-B117-6FEF-547B00B05A6A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377145" y="3944712"/>
                <a:ext cx="214038" cy="1"/>
              </a:xfrm>
              <a:prstGeom prst="straightConnector1">
                <a:avLst/>
              </a:prstGeom>
              <a:ln w="28575">
                <a:tailEnd type="triangle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7" name="Group 36">
              <a:extLst>
                <a:ext uri="{FF2B5EF4-FFF2-40B4-BE49-F238E27FC236}">
                  <a16:creationId xmlns:a16="http://schemas.microsoft.com/office/drawing/2014/main" id="{958EFD15-7901-6587-2E9A-4093A3045971}"/>
                </a:ext>
              </a:extLst>
            </p:cNvPr>
            <p:cNvGrpSpPr/>
            <p:nvPr/>
          </p:nvGrpSpPr>
          <p:grpSpPr>
            <a:xfrm>
              <a:off x="7003031" y="3305248"/>
              <a:ext cx="863575" cy="276999"/>
              <a:chOff x="1727608" y="3776717"/>
              <a:chExt cx="863575" cy="276999"/>
            </a:xfrm>
          </p:grpSpPr>
          <p:sp>
            <p:nvSpPr>
              <p:cNvPr id="38" name="TextBox 37">
                <a:extLst>
                  <a:ext uri="{FF2B5EF4-FFF2-40B4-BE49-F238E27FC236}">
                    <a16:creationId xmlns:a16="http://schemas.microsoft.com/office/drawing/2014/main" id="{63970781-3330-77F1-8726-5384E0276A6A}"/>
                  </a:ext>
                </a:extLst>
              </p:cNvPr>
              <p:cNvSpPr txBox="1"/>
              <p:nvPr/>
            </p:nvSpPr>
            <p:spPr>
              <a:xfrm>
                <a:off x="1727608" y="3776717"/>
                <a:ext cx="64953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0 </a:t>
                </a:r>
                <a:r>
                  <a:rPr lang="en-US" sz="12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39" name="Straight Arrow Connector 38">
                <a:extLst>
                  <a:ext uri="{FF2B5EF4-FFF2-40B4-BE49-F238E27FC236}">
                    <a16:creationId xmlns:a16="http://schemas.microsoft.com/office/drawing/2014/main" id="{6E1F11E8-8D61-023C-21A0-584BDD20526D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377145" y="3944712"/>
                <a:ext cx="214038" cy="1"/>
              </a:xfrm>
              <a:prstGeom prst="straightConnector1">
                <a:avLst/>
              </a:prstGeom>
              <a:ln w="28575">
                <a:tailEnd type="triangle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2" name="Subtitle 2">
              <a:extLst>
                <a:ext uri="{FF2B5EF4-FFF2-40B4-BE49-F238E27FC236}">
                  <a16:creationId xmlns:a16="http://schemas.microsoft.com/office/drawing/2014/main" id="{F6F79506-34A1-3EC7-F4F5-DED270A0DD26}"/>
                </a:ext>
              </a:extLst>
            </p:cNvPr>
            <p:cNvSpPr txBox="1">
              <a:spLocks/>
            </p:cNvSpPr>
            <p:nvPr/>
          </p:nvSpPr>
          <p:spPr>
            <a:xfrm>
              <a:off x="742413" y="5761584"/>
              <a:ext cx="8546538" cy="606300"/>
            </a:xfrm>
            <a:prstGeom prst="rect">
              <a:avLst/>
            </a:prstGeom>
          </p:spPr>
          <p:txBody>
            <a:bodyPr>
              <a:normAutofit fontScale="85000" lnSpcReduction="10000"/>
            </a:bodyPr>
            <a:lstStyle>
              <a:lvl1pPr marL="228600" indent="-228600" algn="l" defTabSz="914400" rtl="0" eaLnBrk="1" latinLnBrk="0" hangingPunct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6858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430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6002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0574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5146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9718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4290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8862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indent="0">
                <a:buNone/>
              </a:pPr>
              <a:r>
                <a:rPr lang="en-US" b="1" dirty="0"/>
                <a:t>Figure S4: </a:t>
              </a:r>
              <a:r>
                <a:rPr lang="en-US" dirty="0"/>
                <a:t>Original blots of Tubulin and AKT protein expression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15562397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356D839-6973-CB94-5F9F-8A20004D781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13C242BE-1617-0635-A24D-4E244C74E838}"/>
              </a:ext>
            </a:extLst>
          </p:cNvPr>
          <p:cNvGrpSpPr/>
          <p:nvPr/>
        </p:nvGrpSpPr>
        <p:grpSpPr>
          <a:xfrm>
            <a:off x="289844" y="990313"/>
            <a:ext cx="11463099" cy="5377571"/>
            <a:chOff x="289844" y="990313"/>
            <a:chExt cx="11463099" cy="5377571"/>
          </a:xfrm>
        </p:grpSpPr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60A06179-8825-D366-5FBC-DAC641A1599B}"/>
                </a:ext>
              </a:extLst>
            </p:cNvPr>
            <p:cNvSpPr txBox="1"/>
            <p:nvPr/>
          </p:nvSpPr>
          <p:spPr>
            <a:xfrm>
              <a:off x="3341586" y="990313"/>
              <a:ext cx="6908543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800" b="1" dirty="0"/>
                <a:t>Tubulin						</a:t>
              </a:r>
              <a:r>
                <a:rPr lang="en-US" sz="1800" b="1" dirty="0" err="1"/>
                <a:t>Nf</a:t>
              </a:r>
              <a:r>
                <a:rPr lang="en-US" sz="1800" b="1" dirty="0"/>
                <a:t>-kB</a:t>
              </a:r>
              <a:endParaRPr lang="en-US" dirty="0"/>
            </a:p>
          </p:txBody>
        </p:sp>
        <p:pic>
          <p:nvPicPr>
            <p:cNvPr id="8" name="Picture 7" descr="A close-up of a line&#10;&#10;AI-generated content may be incorrect.">
              <a:extLst>
                <a:ext uri="{FF2B5EF4-FFF2-40B4-BE49-F238E27FC236}">
                  <a16:creationId xmlns:a16="http://schemas.microsoft.com/office/drawing/2014/main" id="{F19619DE-EF1D-B1B4-00F3-DAF962278685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717909" y="1547665"/>
              <a:ext cx="4686300" cy="3670300"/>
            </a:xfrm>
            <a:prstGeom prst="rect">
              <a:avLst/>
            </a:prstGeom>
          </p:spPr>
        </p:pic>
        <p:pic>
          <p:nvPicPr>
            <p:cNvPr id="3" name="Picture 2" descr="A close-up of a black and white image&#10;&#10;AI-generated content may be incorrect.">
              <a:extLst>
                <a:ext uri="{FF2B5EF4-FFF2-40B4-BE49-F238E27FC236}">
                  <a16:creationId xmlns:a16="http://schemas.microsoft.com/office/drawing/2014/main" id="{9AAF1A5E-BA80-7F17-85FD-0B5E78ADF587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066643" y="1509565"/>
              <a:ext cx="4686300" cy="3708400"/>
            </a:xfrm>
            <a:prstGeom prst="rect">
              <a:avLst/>
            </a:prstGeom>
          </p:spPr>
        </p:pic>
        <p:grpSp>
          <p:nvGrpSpPr>
            <p:cNvPr id="19" name="Group 18">
              <a:extLst>
                <a:ext uri="{FF2B5EF4-FFF2-40B4-BE49-F238E27FC236}">
                  <a16:creationId xmlns:a16="http://schemas.microsoft.com/office/drawing/2014/main" id="{718525E8-129D-E5F9-BBFD-01CBC56E0E8A}"/>
                </a:ext>
              </a:extLst>
            </p:cNvPr>
            <p:cNvGrpSpPr/>
            <p:nvPr/>
          </p:nvGrpSpPr>
          <p:grpSpPr>
            <a:xfrm>
              <a:off x="2722456" y="3003357"/>
              <a:ext cx="2613182" cy="965307"/>
              <a:chOff x="2722456" y="3003357"/>
              <a:chExt cx="2613182" cy="965307"/>
            </a:xfrm>
          </p:grpSpPr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1D2498FB-62C7-DCF2-F517-98427AEDC3D1}"/>
                  </a:ext>
                </a:extLst>
              </p:cNvPr>
              <p:cNvSpPr txBox="1"/>
              <p:nvPr/>
            </p:nvSpPr>
            <p:spPr>
              <a:xfrm>
                <a:off x="2931773" y="3003357"/>
                <a:ext cx="508473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4 h</a:t>
                </a:r>
              </a:p>
            </p:txBody>
          </p:sp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A564F6C6-8896-F086-5297-24002EAB1BCD}"/>
                  </a:ext>
                </a:extLst>
              </p:cNvPr>
              <p:cNvSpPr txBox="1"/>
              <p:nvPr/>
            </p:nvSpPr>
            <p:spPr>
              <a:xfrm rot="17813602">
                <a:off x="2537627" y="3506835"/>
                <a:ext cx="646658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TRL</a:t>
                </a:r>
                <a:endParaRPr lang="en-US" sz="1200" dirty="0"/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204BE80D-18DB-4673-F62D-0500BD95008E}"/>
                  </a:ext>
                </a:extLst>
              </p:cNvPr>
              <p:cNvSpPr txBox="1"/>
              <p:nvPr/>
            </p:nvSpPr>
            <p:spPr>
              <a:xfrm rot="17523636">
                <a:off x="2820865" y="3506835"/>
                <a:ext cx="539546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:40</a:t>
                </a:r>
                <a:endParaRPr lang="en-US" sz="1200" dirty="0"/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4F76D3BD-E68A-CD74-DA9D-B4732219E38F}"/>
                  </a:ext>
                </a:extLst>
              </p:cNvPr>
              <p:cNvSpPr txBox="1"/>
              <p:nvPr/>
            </p:nvSpPr>
            <p:spPr>
              <a:xfrm rot="17523636">
                <a:off x="3050548" y="3529192"/>
                <a:ext cx="539546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:60</a:t>
                </a:r>
                <a:endParaRPr lang="en-US" sz="1200" dirty="0"/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3D6D9050-FEE7-E96D-9C83-E38A7F2C0338}"/>
                  </a:ext>
                </a:extLst>
              </p:cNvPr>
              <p:cNvSpPr txBox="1"/>
              <p:nvPr/>
            </p:nvSpPr>
            <p:spPr>
              <a:xfrm rot="17523636">
                <a:off x="3280232" y="3529190"/>
                <a:ext cx="539546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:80</a:t>
                </a:r>
                <a:endParaRPr lang="en-US" sz="1200" dirty="0"/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E3AE3A4E-40E7-F9DC-EBEC-688E8245FE55}"/>
                  </a:ext>
                </a:extLst>
              </p:cNvPr>
              <p:cNvSpPr txBox="1"/>
              <p:nvPr/>
            </p:nvSpPr>
            <p:spPr>
              <a:xfrm rot="17523636">
                <a:off x="3469827" y="3476447"/>
                <a:ext cx="539546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A</a:t>
                </a:r>
                <a:endParaRPr lang="en-US" sz="1200" dirty="0"/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59F8C0D6-845C-43CF-64FC-1342FA521245}"/>
                  </a:ext>
                </a:extLst>
              </p:cNvPr>
              <p:cNvSpPr txBox="1"/>
              <p:nvPr/>
            </p:nvSpPr>
            <p:spPr>
              <a:xfrm>
                <a:off x="4392646" y="3051959"/>
                <a:ext cx="508473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4 h</a:t>
                </a:r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C8E6C901-1003-C71F-7EC3-0BF0B3985559}"/>
                  </a:ext>
                </a:extLst>
              </p:cNvPr>
              <p:cNvSpPr txBox="1"/>
              <p:nvPr/>
            </p:nvSpPr>
            <p:spPr>
              <a:xfrm rot="17813602">
                <a:off x="3995166" y="3437571"/>
                <a:ext cx="646658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TRL</a:t>
                </a:r>
                <a:endParaRPr lang="en-US" sz="1200" dirty="0"/>
              </a:p>
            </p:txBody>
          </p: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A1EC5E14-3D95-68A1-D9E3-A6B9FCCAD94D}"/>
                  </a:ext>
                </a:extLst>
              </p:cNvPr>
              <p:cNvSpPr txBox="1"/>
              <p:nvPr/>
            </p:nvSpPr>
            <p:spPr>
              <a:xfrm rot="17523636">
                <a:off x="4278404" y="3496563"/>
                <a:ext cx="539546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:40</a:t>
                </a:r>
                <a:endParaRPr lang="en-US" sz="1200" dirty="0"/>
              </a:p>
            </p:txBody>
          </p: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8F6A2ECA-A763-F9FA-3C86-1A237E1F5535}"/>
                  </a:ext>
                </a:extLst>
              </p:cNvPr>
              <p:cNvSpPr txBox="1"/>
              <p:nvPr/>
            </p:nvSpPr>
            <p:spPr>
              <a:xfrm rot="17523636">
                <a:off x="4508087" y="3474676"/>
                <a:ext cx="539546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:60</a:t>
                </a:r>
                <a:endParaRPr lang="en-US" sz="1200" dirty="0"/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3174E766-2A7E-D319-0F04-17B8C8E74C4B}"/>
                  </a:ext>
                </a:extLst>
              </p:cNvPr>
              <p:cNvSpPr txBox="1"/>
              <p:nvPr/>
            </p:nvSpPr>
            <p:spPr>
              <a:xfrm rot="17523636">
                <a:off x="4737771" y="3459926"/>
                <a:ext cx="539546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:80</a:t>
                </a:r>
                <a:endParaRPr lang="en-US" sz="1200" dirty="0"/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67C3D567-2624-1DD7-DC2F-25CFDAB9B03D}"/>
                  </a:ext>
                </a:extLst>
              </p:cNvPr>
              <p:cNvSpPr txBox="1"/>
              <p:nvPr/>
            </p:nvSpPr>
            <p:spPr>
              <a:xfrm rot="17523636">
                <a:off x="4927366" y="3407183"/>
                <a:ext cx="539546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A</a:t>
                </a:r>
                <a:endParaRPr lang="en-US" sz="1200" dirty="0"/>
              </a:p>
            </p:txBody>
          </p:sp>
        </p:grpSp>
        <p:pic>
          <p:nvPicPr>
            <p:cNvPr id="20" name="Picture 2" descr="_image_0">
              <a:extLst>
                <a:ext uri="{FF2B5EF4-FFF2-40B4-BE49-F238E27FC236}">
                  <a16:creationId xmlns:a16="http://schemas.microsoft.com/office/drawing/2014/main" id="{BD29E972-EED7-74ED-CB82-941C1F121F5C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1262" r="43085"/>
            <a:stretch>
              <a:fillRect/>
            </a:stretch>
          </p:blipFill>
          <p:spPr bwMode="auto">
            <a:xfrm>
              <a:off x="289844" y="1420332"/>
              <a:ext cx="902039" cy="387880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21" name="Group 20">
              <a:extLst>
                <a:ext uri="{FF2B5EF4-FFF2-40B4-BE49-F238E27FC236}">
                  <a16:creationId xmlns:a16="http://schemas.microsoft.com/office/drawing/2014/main" id="{D632F6A7-837B-4FF9-C606-97A74364A03E}"/>
                </a:ext>
              </a:extLst>
            </p:cNvPr>
            <p:cNvGrpSpPr/>
            <p:nvPr/>
          </p:nvGrpSpPr>
          <p:grpSpPr>
            <a:xfrm>
              <a:off x="1757104" y="3761969"/>
              <a:ext cx="863575" cy="276999"/>
              <a:chOff x="1727608" y="3776717"/>
              <a:chExt cx="863575" cy="276999"/>
            </a:xfrm>
          </p:grpSpPr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19F6B243-694E-A9B5-B4B7-A12253E3FAC8}"/>
                  </a:ext>
                </a:extLst>
              </p:cNvPr>
              <p:cNvSpPr txBox="1"/>
              <p:nvPr/>
            </p:nvSpPr>
            <p:spPr>
              <a:xfrm>
                <a:off x="1727608" y="3776717"/>
                <a:ext cx="64953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5 </a:t>
                </a:r>
                <a:r>
                  <a:rPr lang="en-US" sz="12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23" name="Straight Arrow Connector 22">
                <a:extLst>
                  <a:ext uri="{FF2B5EF4-FFF2-40B4-BE49-F238E27FC236}">
                    <a16:creationId xmlns:a16="http://schemas.microsoft.com/office/drawing/2014/main" id="{34BC6B19-272B-8D41-E4FA-23FF86EAB975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377145" y="3944712"/>
                <a:ext cx="214038" cy="1"/>
              </a:xfrm>
              <a:prstGeom prst="straightConnector1">
                <a:avLst/>
              </a:prstGeom>
              <a:ln w="28575">
                <a:tailEnd type="triangle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4" name="Group 23">
              <a:extLst>
                <a:ext uri="{FF2B5EF4-FFF2-40B4-BE49-F238E27FC236}">
                  <a16:creationId xmlns:a16="http://schemas.microsoft.com/office/drawing/2014/main" id="{09EC0F85-AC6F-734F-0DAA-78AE91364ADB}"/>
                </a:ext>
              </a:extLst>
            </p:cNvPr>
            <p:cNvGrpSpPr/>
            <p:nvPr/>
          </p:nvGrpSpPr>
          <p:grpSpPr>
            <a:xfrm>
              <a:off x="7081391" y="3134031"/>
              <a:ext cx="863575" cy="276999"/>
              <a:chOff x="1727608" y="3776717"/>
              <a:chExt cx="863575" cy="276999"/>
            </a:xfrm>
          </p:grpSpPr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0AE9F9A5-8DF4-B24A-3042-4C2D0A298B93}"/>
                  </a:ext>
                </a:extLst>
              </p:cNvPr>
              <p:cNvSpPr txBox="1"/>
              <p:nvPr/>
            </p:nvSpPr>
            <p:spPr>
              <a:xfrm>
                <a:off x="1727608" y="3776717"/>
                <a:ext cx="64953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5 </a:t>
                </a:r>
                <a:r>
                  <a:rPr lang="en-US" sz="12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26" name="Straight Arrow Connector 25">
                <a:extLst>
                  <a:ext uri="{FF2B5EF4-FFF2-40B4-BE49-F238E27FC236}">
                    <a16:creationId xmlns:a16="http://schemas.microsoft.com/office/drawing/2014/main" id="{F8B023A5-1AE2-3977-1D1B-C8A5E4631539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377145" y="3944712"/>
                <a:ext cx="214038" cy="1"/>
              </a:xfrm>
              <a:prstGeom prst="straightConnector1">
                <a:avLst/>
              </a:prstGeom>
              <a:ln w="28575">
                <a:tailEnd type="triangle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7" name="Group 26">
              <a:extLst>
                <a:ext uri="{FF2B5EF4-FFF2-40B4-BE49-F238E27FC236}">
                  <a16:creationId xmlns:a16="http://schemas.microsoft.com/office/drawing/2014/main" id="{06B45D03-7D6D-F1C3-FB69-19A9832FB904}"/>
                </a:ext>
              </a:extLst>
            </p:cNvPr>
            <p:cNvGrpSpPr/>
            <p:nvPr/>
          </p:nvGrpSpPr>
          <p:grpSpPr>
            <a:xfrm>
              <a:off x="8042124" y="2395411"/>
              <a:ext cx="2613182" cy="921972"/>
              <a:chOff x="8229091" y="2953231"/>
              <a:chExt cx="2613182" cy="921972"/>
            </a:xfrm>
          </p:grpSpPr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6F30F614-E374-002C-A612-F5D840D449FF}"/>
                  </a:ext>
                </a:extLst>
              </p:cNvPr>
              <p:cNvSpPr txBox="1"/>
              <p:nvPr/>
            </p:nvSpPr>
            <p:spPr>
              <a:xfrm>
                <a:off x="8526170" y="2953231"/>
                <a:ext cx="508473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4 h</a:t>
                </a:r>
              </a:p>
            </p:txBody>
          </p:sp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65FD3E84-14F5-771F-9D31-CAD1F6CF9F9B}"/>
                  </a:ext>
                </a:extLst>
              </p:cNvPr>
              <p:cNvSpPr txBox="1"/>
              <p:nvPr/>
            </p:nvSpPr>
            <p:spPr>
              <a:xfrm rot="17813602">
                <a:off x="8044262" y="3413374"/>
                <a:ext cx="646658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TRL</a:t>
                </a:r>
                <a:endParaRPr lang="en-US" sz="1200" dirty="0"/>
              </a:p>
            </p:txBody>
          </p:sp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830F4CF9-6233-1A1F-46B0-50897B0565D7}"/>
                  </a:ext>
                </a:extLst>
              </p:cNvPr>
              <p:cNvSpPr txBox="1"/>
              <p:nvPr/>
            </p:nvSpPr>
            <p:spPr>
              <a:xfrm rot="17523636">
                <a:off x="8356996" y="3413374"/>
                <a:ext cx="539546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:40</a:t>
                </a:r>
                <a:endParaRPr lang="en-US" sz="1200" dirty="0"/>
              </a:p>
            </p:txBody>
          </p:sp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7A25A110-7EAA-301C-D8A3-E766B5C6EA06}"/>
                  </a:ext>
                </a:extLst>
              </p:cNvPr>
              <p:cNvSpPr txBox="1"/>
              <p:nvPr/>
            </p:nvSpPr>
            <p:spPr>
              <a:xfrm rot="17523636">
                <a:off x="8557183" y="3435731"/>
                <a:ext cx="539546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:60</a:t>
                </a:r>
                <a:endParaRPr lang="en-US" sz="1200" dirty="0"/>
              </a:p>
            </p:txBody>
          </p:sp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EE0635C5-2AEC-53DD-BFDA-12B74ED95F82}"/>
                  </a:ext>
                </a:extLst>
              </p:cNvPr>
              <p:cNvSpPr txBox="1"/>
              <p:nvPr/>
            </p:nvSpPr>
            <p:spPr>
              <a:xfrm rot="17523636">
                <a:off x="8772119" y="3435729"/>
                <a:ext cx="539546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:80</a:t>
                </a:r>
                <a:endParaRPr lang="en-US" sz="1200" dirty="0"/>
              </a:p>
            </p:txBody>
          </p:sp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A67C22C3-0AE8-73D1-9DC9-90049E109F7B}"/>
                  </a:ext>
                </a:extLst>
              </p:cNvPr>
              <p:cNvSpPr txBox="1"/>
              <p:nvPr/>
            </p:nvSpPr>
            <p:spPr>
              <a:xfrm rot="17523636">
                <a:off x="8976462" y="3382986"/>
                <a:ext cx="539546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A</a:t>
                </a:r>
                <a:endParaRPr lang="en-US" sz="1200" dirty="0"/>
              </a:p>
            </p:txBody>
          </p:sp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3E62AB48-7862-D2B9-7C21-9C91183BEE91}"/>
                  </a:ext>
                </a:extLst>
              </p:cNvPr>
              <p:cNvSpPr txBox="1"/>
              <p:nvPr/>
            </p:nvSpPr>
            <p:spPr>
              <a:xfrm>
                <a:off x="9899281" y="2958498"/>
                <a:ext cx="508473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4 h</a:t>
                </a:r>
              </a:p>
            </p:txBody>
          </p:sp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18F28C92-CF38-7DF1-6DF4-035B13E177A5}"/>
                  </a:ext>
                </a:extLst>
              </p:cNvPr>
              <p:cNvSpPr txBox="1"/>
              <p:nvPr/>
            </p:nvSpPr>
            <p:spPr>
              <a:xfrm rot="17813602">
                <a:off x="9501801" y="3344110"/>
                <a:ext cx="646658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TRL</a:t>
                </a:r>
                <a:endParaRPr lang="en-US" sz="1200" dirty="0"/>
              </a:p>
            </p:txBody>
          </p:sp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F5CADE51-48F2-311A-36AE-10CABA0EEEDF}"/>
                  </a:ext>
                </a:extLst>
              </p:cNvPr>
              <p:cNvSpPr txBox="1"/>
              <p:nvPr/>
            </p:nvSpPr>
            <p:spPr>
              <a:xfrm rot="17523636">
                <a:off x="9785039" y="3403102"/>
                <a:ext cx="539546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:40</a:t>
                </a:r>
                <a:endParaRPr lang="en-US" sz="1200" dirty="0"/>
              </a:p>
            </p:txBody>
          </p:sp>
          <p:sp>
            <p:nvSpPr>
              <p:cNvPr id="37" name="TextBox 36">
                <a:extLst>
                  <a:ext uri="{FF2B5EF4-FFF2-40B4-BE49-F238E27FC236}">
                    <a16:creationId xmlns:a16="http://schemas.microsoft.com/office/drawing/2014/main" id="{2A9982DB-1704-B36F-6336-7321CF2EE4B9}"/>
                  </a:ext>
                </a:extLst>
              </p:cNvPr>
              <p:cNvSpPr txBox="1"/>
              <p:nvPr/>
            </p:nvSpPr>
            <p:spPr>
              <a:xfrm rot="17523636">
                <a:off x="10014722" y="3381215"/>
                <a:ext cx="539546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:60</a:t>
                </a:r>
                <a:endParaRPr lang="en-US" sz="1200" dirty="0"/>
              </a:p>
            </p:txBody>
          </p:sp>
          <p:sp>
            <p:nvSpPr>
              <p:cNvPr id="38" name="TextBox 37">
                <a:extLst>
                  <a:ext uri="{FF2B5EF4-FFF2-40B4-BE49-F238E27FC236}">
                    <a16:creationId xmlns:a16="http://schemas.microsoft.com/office/drawing/2014/main" id="{D40BFA19-E5D7-85D0-D15B-661F3B347BE3}"/>
                  </a:ext>
                </a:extLst>
              </p:cNvPr>
              <p:cNvSpPr txBox="1"/>
              <p:nvPr/>
            </p:nvSpPr>
            <p:spPr>
              <a:xfrm rot="17523636">
                <a:off x="10244406" y="3366465"/>
                <a:ext cx="539546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:80</a:t>
                </a:r>
                <a:endParaRPr lang="en-US" sz="1200" dirty="0"/>
              </a:p>
            </p:txBody>
          </p:sp>
          <p:sp>
            <p:nvSpPr>
              <p:cNvPr id="39" name="TextBox 38">
                <a:extLst>
                  <a:ext uri="{FF2B5EF4-FFF2-40B4-BE49-F238E27FC236}">
                    <a16:creationId xmlns:a16="http://schemas.microsoft.com/office/drawing/2014/main" id="{D996FD32-50DE-011D-4C10-71DB55FE4F75}"/>
                  </a:ext>
                </a:extLst>
              </p:cNvPr>
              <p:cNvSpPr txBox="1"/>
              <p:nvPr/>
            </p:nvSpPr>
            <p:spPr>
              <a:xfrm rot="17523636">
                <a:off x="10434001" y="3313722"/>
                <a:ext cx="539546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A</a:t>
                </a:r>
                <a:endParaRPr lang="en-US" sz="1200" dirty="0"/>
              </a:p>
            </p:txBody>
          </p:sp>
        </p:grpSp>
        <p:sp>
          <p:nvSpPr>
            <p:cNvPr id="2" name="Subtitle 2">
              <a:extLst>
                <a:ext uri="{FF2B5EF4-FFF2-40B4-BE49-F238E27FC236}">
                  <a16:creationId xmlns:a16="http://schemas.microsoft.com/office/drawing/2014/main" id="{8F6327D2-15AE-1AAC-6AA5-E6158B0EB614}"/>
                </a:ext>
              </a:extLst>
            </p:cNvPr>
            <p:cNvSpPr txBox="1">
              <a:spLocks/>
            </p:cNvSpPr>
            <p:nvPr/>
          </p:nvSpPr>
          <p:spPr>
            <a:xfrm>
              <a:off x="742413" y="5761584"/>
              <a:ext cx="9125432" cy="606300"/>
            </a:xfrm>
            <a:prstGeom prst="rect">
              <a:avLst/>
            </a:prstGeom>
          </p:spPr>
          <p:txBody>
            <a:bodyPr>
              <a:noAutofit/>
            </a:bodyPr>
            <a:lstStyle>
              <a:lvl1pPr marL="228600" indent="-228600" algn="l" defTabSz="914400" rtl="0" eaLnBrk="1" latinLnBrk="0" hangingPunct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6858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430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6002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0574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5146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9718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4290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8862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indent="0">
                <a:buNone/>
              </a:pPr>
              <a:r>
                <a:rPr lang="en-US" sz="2400" b="1" dirty="0"/>
                <a:t>Figure S5: </a:t>
              </a:r>
              <a:r>
                <a:rPr lang="en-US" sz="2400" dirty="0"/>
                <a:t>Original blots of Tubulin and </a:t>
              </a:r>
              <a:r>
                <a:rPr lang="en-US" sz="2400" dirty="0" err="1"/>
                <a:t>Nf</a:t>
              </a:r>
              <a:r>
                <a:rPr lang="en-US" sz="2400" dirty="0"/>
                <a:t>-kB protein expression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400016505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F1E897A-CD8D-E514-25A0-C91B310C9F0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Group 12">
            <a:extLst>
              <a:ext uri="{FF2B5EF4-FFF2-40B4-BE49-F238E27FC236}">
                <a16:creationId xmlns:a16="http://schemas.microsoft.com/office/drawing/2014/main" id="{9F22EE2A-FB1B-65DF-5B1A-264246A693F2}"/>
              </a:ext>
            </a:extLst>
          </p:cNvPr>
          <p:cNvGrpSpPr/>
          <p:nvPr/>
        </p:nvGrpSpPr>
        <p:grpSpPr>
          <a:xfrm>
            <a:off x="289844" y="990313"/>
            <a:ext cx="11527641" cy="5377571"/>
            <a:chOff x="289844" y="990313"/>
            <a:chExt cx="11527641" cy="5377571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707A761C-3F12-43DE-79E4-7C765E56F91A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062605" y="1560553"/>
              <a:ext cx="4754880" cy="3749781"/>
            </a:xfrm>
            <a:prstGeom prst="rect">
              <a:avLst/>
            </a:prstGeom>
          </p:spPr>
        </p:pic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6662519B-C8CA-5433-D26C-51668162AD79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717909" y="1547665"/>
              <a:ext cx="4754880" cy="3762669"/>
            </a:xfrm>
            <a:prstGeom prst="rect">
              <a:avLst/>
            </a:prstGeom>
          </p:spPr>
        </p:pic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38AABB4D-C169-6666-BA7D-6C91DD33D7C0}"/>
                </a:ext>
              </a:extLst>
            </p:cNvPr>
            <p:cNvSpPr txBox="1"/>
            <p:nvPr/>
          </p:nvSpPr>
          <p:spPr>
            <a:xfrm>
              <a:off x="3341586" y="990313"/>
              <a:ext cx="6908543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800" b="1" dirty="0"/>
                <a:t>Tubulin						COX-2</a:t>
              </a:r>
              <a:endParaRPr lang="en-US" dirty="0"/>
            </a:p>
          </p:txBody>
        </p:sp>
        <p:grpSp>
          <p:nvGrpSpPr>
            <p:cNvPr id="34" name="Group 33">
              <a:extLst>
                <a:ext uri="{FF2B5EF4-FFF2-40B4-BE49-F238E27FC236}">
                  <a16:creationId xmlns:a16="http://schemas.microsoft.com/office/drawing/2014/main" id="{AA16D245-6C18-5DE9-612E-8E7922934E3D}"/>
                </a:ext>
              </a:extLst>
            </p:cNvPr>
            <p:cNvGrpSpPr/>
            <p:nvPr/>
          </p:nvGrpSpPr>
          <p:grpSpPr>
            <a:xfrm>
              <a:off x="2685614" y="2437880"/>
              <a:ext cx="2637236" cy="1031880"/>
              <a:chOff x="2685614" y="2437880"/>
              <a:chExt cx="2637236" cy="1031880"/>
            </a:xfrm>
          </p:grpSpPr>
          <p:sp>
            <p:nvSpPr>
              <p:cNvPr id="4" name="TextBox 3">
                <a:extLst>
                  <a:ext uri="{FF2B5EF4-FFF2-40B4-BE49-F238E27FC236}">
                    <a16:creationId xmlns:a16="http://schemas.microsoft.com/office/drawing/2014/main" id="{481E63A9-B315-F2CC-470B-210E42C55B55}"/>
                  </a:ext>
                </a:extLst>
              </p:cNvPr>
              <p:cNvSpPr txBox="1"/>
              <p:nvPr/>
            </p:nvSpPr>
            <p:spPr>
              <a:xfrm>
                <a:off x="3089296" y="2437880"/>
                <a:ext cx="508473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4 h</a:t>
                </a:r>
              </a:p>
            </p:txBody>
          </p:sp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B3BA3619-718B-FA2D-FB16-87D6D090F8CB}"/>
                  </a:ext>
                </a:extLst>
              </p:cNvPr>
              <p:cNvSpPr txBox="1"/>
              <p:nvPr/>
            </p:nvSpPr>
            <p:spPr>
              <a:xfrm rot="17813602">
                <a:off x="3544213" y="2988458"/>
                <a:ext cx="646658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TRL</a:t>
                </a:r>
                <a:endParaRPr lang="en-US" sz="1200" dirty="0"/>
              </a:p>
            </p:txBody>
          </p:sp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28A63C3B-D26F-48C0-02CF-F5603F63311D}"/>
                  </a:ext>
                </a:extLst>
              </p:cNvPr>
              <p:cNvSpPr txBox="1"/>
              <p:nvPr/>
            </p:nvSpPr>
            <p:spPr>
              <a:xfrm rot="17523636">
                <a:off x="2554341" y="2966104"/>
                <a:ext cx="539546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:40</a:t>
                </a:r>
                <a:endParaRPr lang="en-US" sz="1200" dirty="0"/>
              </a:p>
            </p:txBody>
          </p:sp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A7E91C52-BBE8-A7D9-1CAA-347BD572752F}"/>
                  </a:ext>
                </a:extLst>
              </p:cNvPr>
              <p:cNvSpPr txBox="1"/>
              <p:nvPr/>
            </p:nvSpPr>
            <p:spPr>
              <a:xfrm rot="17523636">
                <a:off x="2843016" y="3003209"/>
                <a:ext cx="539546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:60</a:t>
                </a:r>
                <a:endParaRPr lang="en-US" sz="1200" dirty="0"/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5261AF3E-0A8C-34E7-911A-D45FEF9C1797}"/>
                  </a:ext>
                </a:extLst>
              </p:cNvPr>
              <p:cNvSpPr txBox="1"/>
              <p:nvPr/>
            </p:nvSpPr>
            <p:spPr>
              <a:xfrm rot="17523636">
                <a:off x="3102196" y="2988459"/>
                <a:ext cx="539546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:80</a:t>
                </a:r>
                <a:endParaRPr lang="en-US" sz="1200" dirty="0"/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099D7761-E6A1-53E0-D4C0-87BACEE65D07}"/>
                  </a:ext>
                </a:extLst>
              </p:cNvPr>
              <p:cNvSpPr txBox="1"/>
              <p:nvPr/>
            </p:nvSpPr>
            <p:spPr>
              <a:xfrm rot="17523636">
                <a:off x="3319441" y="2979740"/>
                <a:ext cx="539546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A</a:t>
                </a:r>
                <a:endParaRPr lang="en-US" sz="1200" dirty="0"/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1AF72980-8F18-8255-452D-AC7469647A12}"/>
                  </a:ext>
                </a:extLst>
              </p:cNvPr>
              <p:cNvSpPr txBox="1"/>
              <p:nvPr/>
            </p:nvSpPr>
            <p:spPr>
              <a:xfrm>
                <a:off x="4427050" y="2437880"/>
                <a:ext cx="508473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8 h</a:t>
                </a:r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4AF9C4B9-BEB1-180E-87D6-F7915E7E488B}"/>
                  </a:ext>
                </a:extLst>
              </p:cNvPr>
              <p:cNvSpPr txBox="1"/>
              <p:nvPr/>
            </p:nvSpPr>
            <p:spPr>
              <a:xfrm rot="17813602">
                <a:off x="4861022" y="3007931"/>
                <a:ext cx="646658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TRL</a:t>
                </a:r>
                <a:endParaRPr lang="en-US" sz="1200" dirty="0"/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1002AC7F-F404-32E8-51FD-71C99B23D8C8}"/>
                  </a:ext>
                </a:extLst>
              </p:cNvPr>
              <p:cNvSpPr txBox="1"/>
              <p:nvPr/>
            </p:nvSpPr>
            <p:spPr>
              <a:xfrm rot="17523636">
                <a:off x="3900646" y="3044569"/>
                <a:ext cx="539546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:40</a:t>
                </a:r>
                <a:endParaRPr lang="en-US" sz="1200" dirty="0"/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E85B83BC-3732-1AE0-EC36-3C4E8156D748}"/>
                  </a:ext>
                </a:extLst>
              </p:cNvPr>
              <p:cNvSpPr txBox="1"/>
              <p:nvPr/>
            </p:nvSpPr>
            <p:spPr>
              <a:xfrm rot="17523636">
                <a:off x="4174573" y="3037430"/>
                <a:ext cx="539546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:60</a:t>
                </a:r>
                <a:endParaRPr lang="en-US" sz="1200" dirty="0"/>
              </a:p>
            </p:txBody>
          </p: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41707FF0-D035-E5CC-5395-EB0779F5F170}"/>
                  </a:ext>
                </a:extLst>
              </p:cNvPr>
              <p:cNvSpPr txBox="1"/>
              <p:nvPr/>
            </p:nvSpPr>
            <p:spPr>
              <a:xfrm rot="17523636">
                <a:off x="4419005" y="3037428"/>
                <a:ext cx="539546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:80</a:t>
                </a:r>
                <a:endParaRPr lang="en-US" sz="1200" dirty="0"/>
              </a:p>
            </p:txBody>
          </p: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FC6682CF-4726-30E4-A707-0C87E4BFF13A}"/>
                  </a:ext>
                </a:extLst>
              </p:cNvPr>
              <p:cNvSpPr txBox="1"/>
              <p:nvPr/>
            </p:nvSpPr>
            <p:spPr>
              <a:xfrm rot="17523636">
                <a:off x="4636250" y="3028709"/>
                <a:ext cx="539546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A</a:t>
                </a:r>
                <a:endParaRPr lang="en-US" sz="1200" dirty="0"/>
              </a:p>
            </p:txBody>
          </p:sp>
        </p:grpSp>
        <p:grpSp>
          <p:nvGrpSpPr>
            <p:cNvPr id="35" name="Group 34">
              <a:extLst>
                <a:ext uri="{FF2B5EF4-FFF2-40B4-BE49-F238E27FC236}">
                  <a16:creationId xmlns:a16="http://schemas.microsoft.com/office/drawing/2014/main" id="{94596E2D-7E5D-2727-1A03-E4E860FF5635}"/>
                </a:ext>
              </a:extLst>
            </p:cNvPr>
            <p:cNvGrpSpPr/>
            <p:nvPr/>
          </p:nvGrpSpPr>
          <p:grpSpPr>
            <a:xfrm>
              <a:off x="8312816" y="2151697"/>
              <a:ext cx="2489756" cy="1031880"/>
              <a:chOff x="8312816" y="2151697"/>
              <a:chExt cx="2489756" cy="1031880"/>
            </a:xfrm>
          </p:grpSpPr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577612E5-D01F-CB58-8AAD-1547D65443E3}"/>
                  </a:ext>
                </a:extLst>
              </p:cNvPr>
              <p:cNvSpPr txBox="1"/>
              <p:nvPr/>
            </p:nvSpPr>
            <p:spPr>
              <a:xfrm>
                <a:off x="8569018" y="2151697"/>
                <a:ext cx="508473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4 h</a:t>
                </a:r>
              </a:p>
            </p:txBody>
          </p: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E9ADC165-6FFA-3F22-7853-A035CC3DF19B}"/>
                  </a:ext>
                </a:extLst>
              </p:cNvPr>
              <p:cNvSpPr txBox="1"/>
              <p:nvPr/>
            </p:nvSpPr>
            <p:spPr>
              <a:xfrm rot="17813602">
                <a:off x="9038683" y="2717023"/>
                <a:ext cx="646658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TRL</a:t>
                </a:r>
                <a:endParaRPr lang="en-US" sz="1200" dirty="0"/>
              </a:p>
            </p:txBody>
          </p: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311F071E-EE24-7470-8442-35DB28ABBDF8}"/>
                  </a:ext>
                </a:extLst>
              </p:cNvPr>
              <p:cNvSpPr txBox="1"/>
              <p:nvPr/>
            </p:nvSpPr>
            <p:spPr>
              <a:xfrm rot="17523636">
                <a:off x="8181543" y="2694669"/>
                <a:ext cx="539546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:40</a:t>
                </a:r>
                <a:endParaRPr lang="en-US" sz="1200" dirty="0"/>
              </a:p>
            </p:txBody>
          </p:sp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1711626D-F757-A222-B8F0-FF2A787E8AD1}"/>
                  </a:ext>
                </a:extLst>
              </p:cNvPr>
              <p:cNvSpPr txBox="1"/>
              <p:nvPr/>
            </p:nvSpPr>
            <p:spPr>
              <a:xfrm rot="17523636">
                <a:off x="8425974" y="2731774"/>
                <a:ext cx="539546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:60</a:t>
                </a:r>
                <a:endParaRPr lang="en-US" sz="1200" dirty="0"/>
              </a:p>
            </p:txBody>
          </p: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8C6473FB-0E4F-8DAF-5709-6D1FB89D69CE}"/>
                  </a:ext>
                </a:extLst>
              </p:cNvPr>
              <p:cNvSpPr txBox="1"/>
              <p:nvPr/>
            </p:nvSpPr>
            <p:spPr>
              <a:xfrm rot="17523636">
                <a:off x="8655658" y="2717024"/>
                <a:ext cx="539546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:80</a:t>
                </a:r>
                <a:endParaRPr lang="en-US" sz="1200" dirty="0"/>
              </a:p>
            </p:txBody>
          </p:sp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92771946-F55D-3353-C888-6500E91745D0}"/>
                  </a:ext>
                </a:extLst>
              </p:cNvPr>
              <p:cNvSpPr txBox="1"/>
              <p:nvPr/>
            </p:nvSpPr>
            <p:spPr>
              <a:xfrm rot="17523636">
                <a:off x="8872903" y="2737801"/>
                <a:ext cx="539546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A</a:t>
                </a:r>
                <a:endParaRPr lang="en-US" sz="1200" dirty="0"/>
              </a:p>
            </p:txBody>
          </p:sp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17613874-202A-E497-8278-7018E52BAC56}"/>
                  </a:ext>
                </a:extLst>
              </p:cNvPr>
              <p:cNvSpPr txBox="1"/>
              <p:nvPr/>
            </p:nvSpPr>
            <p:spPr>
              <a:xfrm>
                <a:off x="9906772" y="2151697"/>
                <a:ext cx="508473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8 h</a:t>
                </a:r>
              </a:p>
            </p:txBody>
          </p:sp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9EC6A5EF-5F3F-4FDD-52CF-E8D939FC25BD}"/>
                  </a:ext>
                </a:extLst>
              </p:cNvPr>
              <p:cNvSpPr txBox="1"/>
              <p:nvPr/>
            </p:nvSpPr>
            <p:spPr>
              <a:xfrm rot="17813602">
                <a:off x="10340744" y="2721748"/>
                <a:ext cx="646658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TRL</a:t>
                </a:r>
                <a:endParaRPr lang="en-US" sz="1200" dirty="0"/>
              </a:p>
            </p:txBody>
          </p:sp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4C440AEC-1A20-E384-39AB-61856E5D1BE3}"/>
                  </a:ext>
                </a:extLst>
              </p:cNvPr>
              <p:cNvSpPr txBox="1"/>
              <p:nvPr/>
            </p:nvSpPr>
            <p:spPr>
              <a:xfrm rot="17523636">
                <a:off x="9454108" y="2773134"/>
                <a:ext cx="539546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:40</a:t>
                </a:r>
                <a:endParaRPr lang="en-US" sz="1200" dirty="0"/>
              </a:p>
            </p:txBody>
          </p:sp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00BFDD63-259F-4045-4A96-7099546AC425}"/>
                  </a:ext>
                </a:extLst>
              </p:cNvPr>
              <p:cNvSpPr txBox="1"/>
              <p:nvPr/>
            </p:nvSpPr>
            <p:spPr>
              <a:xfrm rot="17523636">
                <a:off x="9654295" y="2751247"/>
                <a:ext cx="539546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:60</a:t>
                </a:r>
                <a:endParaRPr lang="en-US" sz="1200" dirty="0"/>
              </a:p>
            </p:txBody>
          </p:sp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BB0F09BB-89A3-C457-2113-4BA928EEF323}"/>
                  </a:ext>
                </a:extLst>
              </p:cNvPr>
              <p:cNvSpPr txBox="1"/>
              <p:nvPr/>
            </p:nvSpPr>
            <p:spPr>
              <a:xfrm rot="17523636">
                <a:off x="9898727" y="2751245"/>
                <a:ext cx="539546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:80</a:t>
                </a:r>
                <a:endParaRPr lang="en-US" sz="1200" dirty="0"/>
              </a:p>
            </p:txBody>
          </p:sp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BDB77267-E75D-BF0A-0067-9070D082E77C}"/>
                  </a:ext>
                </a:extLst>
              </p:cNvPr>
              <p:cNvSpPr txBox="1"/>
              <p:nvPr/>
            </p:nvSpPr>
            <p:spPr>
              <a:xfrm rot="17523636">
                <a:off x="10130720" y="2742526"/>
                <a:ext cx="539546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A</a:t>
                </a:r>
                <a:endParaRPr lang="en-US" sz="1200" dirty="0"/>
              </a:p>
            </p:txBody>
          </p:sp>
        </p:grpSp>
        <p:pic>
          <p:nvPicPr>
            <p:cNvPr id="36" name="Picture 2" descr="_image_0">
              <a:extLst>
                <a:ext uri="{FF2B5EF4-FFF2-40B4-BE49-F238E27FC236}">
                  <a16:creationId xmlns:a16="http://schemas.microsoft.com/office/drawing/2014/main" id="{0B0AF6B6-A82A-AEE1-1409-24EB3F06E82B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1262" r="43085"/>
            <a:stretch>
              <a:fillRect/>
            </a:stretch>
          </p:blipFill>
          <p:spPr bwMode="auto">
            <a:xfrm>
              <a:off x="289844" y="1420332"/>
              <a:ext cx="902039" cy="387880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37" name="Group 36">
              <a:extLst>
                <a:ext uri="{FF2B5EF4-FFF2-40B4-BE49-F238E27FC236}">
                  <a16:creationId xmlns:a16="http://schemas.microsoft.com/office/drawing/2014/main" id="{FBC3C2CD-2768-ABA7-19FA-80547E68F0FE}"/>
                </a:ext>
              </a:extLst>
            </p:cNvPr>
            <p:cNvGrpSpPr/>
            <p:nvPr/>
          </p:nvGrpSpPr>
          <p:grpSpPr>
            <a:xfrm>
              <a:off x="1739439" y="3221235"/>
              <a:ext cx="863575" cy="276999"/>
              <a:chOff x="1727608" y="3776717"/>
              <a:chExt cx="863575" cy="276999"/>
            </a:xfrm>
          </p:grpSpPr>
          <p:sp>
            <p:nvSpPr>
              <p:cNvPr id="38" name="TextBox 37">
                <a:extLst>
                  <a:ext uri="{FF2B5EF4-FFF2-40B4-BE49-F238E27FC236}">
                    <a16:creationId xmlns:a16="http://schemas.microsoft.com/office/drawing/2014/main" id="{AB43347A-97E2-6AC2-0ACD-4460E860DC46}"/>
                  </a:ext>
                </a:extLst>
              </p:cNvPr>
              <p:cNvSpPr txBox="1"/>
              <p:nvPr/>
            </p:nvSpPr>
            <p:spPr>
              <a:xfrm>
                <a:off x="1727608" y="3776717"/>
                <a:ext cx="64953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5 </a:t>
                </a:r>
                <a:r>
                  <a:rPr lang="en-US" sz="12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39" name="Straight Arrow Connector 38">
                <a:extLst>
                  <a:ext uri="{FF2B5EF4-FFF2-40B4-BE49-F238E27FC236}">
                    <a16:creationId xmlns:a16="http://schemas.microsoft.com/office/drawing/2014/main" id="{B2493A90-77F5-29CC-E65A-C1285E794DE2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377145" y="3944712"/>
                <a:ext cx="214038" cy="1"/>
              </a:xfrm>
              <a:prstGeom prst="straightConnector1">
                <a:avLst/>
              </a:prstGeom>
              <a:ln w="28575">
                <a:tailEnd type="triangle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40" name="Group 39">
              <a:extLst>
                <a:ext uri="{FF2B5EF4-FFF2-40B4-BE49-F238E27FC236}">
                  <a16:creationId xmlns:a16="http://schemas.microsoft.com/office/drawing/2014/main" id="{7CA5B5C2-3534-4EB6-E127-20920574FB18}"/>
                </a:ext>
              </a:extLst>
            </p:cNvPr>
            <p:cNvGrpSpPr/>
            <p:nvPr/>
          </p:nvGrpSpPr>
          <p:grpSpPr>
            <a:xfrm>
              <a:off x="7240074" y="3693295"/>
              <a:ext cx="863575" cy="276999"/>
              <a:chOff x="1727608" y="3776717"/>
              <a:chExt cx="863575" cy="276999"/>
            </a:xfrm>
          </p:grpSpPr>
          <p:sp>
            <p:nvSpPr>
              <p:cNvPr id="41" name="TextBox 40">
                <a:extLst>
                  <a:ext uri="{FF2B5EF4-FFF2-40B4-BE49-F238E27FC236}">
                    <a16:creationId xmlns:a16="http://schemas.microsoft.com/office/drawing/2014/main" id="{34A44F01-BFE3-2732-DD0E-0EB7E26A19BA}"/>
                  </a:ext>
                </a:extLst>
              </p:cNvPr>
              <p:cNvSpPr txBox="1"/>
              <p:nvPr/>
            </p:nvSpPr>
            <p:spPr>
              <a:xfrm>
                <a:off x="1727608" y="3776717"/>
                <a:ext cx="64953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2 </a:t>
                </a:r>
                <a:r>
                  <a:rPr lang="en-US" sz="12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42" name="Straight Arrow Connector 41">
                <a:extLst>
                  <a:ext uri="{FF2B5EF4-FFF2-40B4-BE49-F238E27FC236}">
                    <a16:creationId xmlns:a16="http://schemas.microsoft.com/office/drawing/2014/main" id="{53E1BC27-AA44-4AF6-C9B5-63E6A48A5446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377145" y="3944712"/>
                <a:ext cx="214038" cy="1"/>
              </a:xfrm>
              <a:prstGeom prst="straightConnector1">
                <a:avLst/>
              </a:prstGeom>
              <a:ln w="28575">
                <a:tailEnd type="triangle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2" name="Subtitle 2">
              <a:extLst>
                <a:ext uri="{FF2B5EF4-FFF2-40B4-BE49-F238E27FC236}">
                  <a16:creationId xmlns:a16="http://schemas.microsoft.com/office/drawing/2014/main" id="{534DC2EA-10F7-200C-EFA5-B8BBE2566C79}"/>
                </a:ext>
              </a:extLst>
            </p:cNvPr>
            <p:cNvSpPr txBox="1">
              <a:spLocks/>
            </p:cNvSpPr>
            <p:nvPr/>
          </p:nvSpPr>
          <p:spPr>
            <a:xfrm>
              <a:off x="742412" y="5761584"/>
              <a:ext cx="8751785" cy="606300"/>
            </a:xfrm>
            <a:prstGeom prst="rect">
              <a:avLst/>
            </a:prstGeom>
          </p:spPr>
          <p:txBody>
            <a:bodyPr>
              <a:noAutofit/>
            </a:bodyPr>
            <a:lstStyle>
              <a:lvl1pPr marL="228600" indent="-228600" algn="l" defTabSz="914400" rtl="0" eaLnBrk="1" latinLnBrk="0" hangingPunct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6858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430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6002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0574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5146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9718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4290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8862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indent="0">
                <a:buNone/>
              </a:pPr>
              <a:r>
                <a:rPr lang="en-US" sz="2400" b="1" dirty="0"/>
                <a:t>Figure S6: </a:t>
              </a:r>
              <a:r>
                <a:rPr lang="en-US" sz="2400" dirty="0"/>
                <a:t>Original blots of Tubulin and COX-2 protein expression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8678225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7</TotalTime>
  <Words>301</Words>
  <Application>Microsoft Office PowerPoint</Application>
  <PresentationFormat>Widescreen</PresentationFormat>
  <Paragraphs>146</Paragraphs>
  <Slides>7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2" baseType="lpstr">
      <vt:lpstr>Aptos</vt:lpstr>
      <vt:lpstr>Aptos Display</vt:lpstr>
      <vt:lpstr>Arial</vt:lpstr>
      <vt:lpstr>Times New Roman</vt:lpstr>
      <vt:lpstr>Office Theme</vt:lpstr>
      <vt:lpstr>Nature’s Synergy: Cellular and Molecular Evaluation of Snail Slime and Its Principal Component, Glycolic Acid, on Keratinocytes, with Preliminary Evidence from Endothelial Cells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Muhammad Rashad</dc:creator>
  <cp:lastModifiedBy>Muhammad Rashad</cp:lastModifiedBy>
  <cp:revision>14</cp:revision>
  <dcterms:created xsi:type="dcterms:W3CDTF">2025-08-09T09:48:20Z</dcterms:created>
  <dcterms:modified xsi:type="dcterms:W3CDTF">2025-09-09T14:07:10Z</dcterms:modified>
</cp:coreProperties>
</file>